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B3BFF"/>
    <a:srgbClr val="FFC6C6"/>
    <a:srgbClr val="A8A8FF"/>
    <a:srgbClr val="FF8080"/>
    <a:srgbClr val="808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7119FF0-9104-4DDB-80D5-FE26F86DB9B3}" v="8" dt="2024-11-12T11:43:11.413"/>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80759" autoAdjust="0"/>
  </p:normalViewPr>
  <p:slideViewPr>
    <p:cSldViewPr snapToGrid="0" showGuides="1">
      <p:cViewPr varScale="1">
        <p:scale>
          <a:sx n="63" d="100"/>
          <a:sy n="63" d="100"/>
        </p:scale>
        <p:origin x="1382" y="5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雄康 大野" userId="289040ba27705a35" providerId="LiveId" clId="{67119FF0-9104-4DDB-80D5-FE26F86DB9B3}"/>
    <pc:docChg chg="modSld">
      <pc:chgData name="雄康 大野" userId="289040ba27705a35" providerId="LiveId" clId="{67119FF0-9104-4DDB-80D5-FE26F86DB9B3}" dt="2024-11-12T11:53:06.969" v="8"/>
      <pc:docMkLst>
        <pc:docMk/>
      </pc:docMkLst>
      <pc:sldChg chg="modSp modNotesTx">
        <pc:chgData name="雄康 大野" userId="289040ba27705a35" providerId="LiveId" clId="{67119FF0-9104-4DDB-80D5-FE26F86DB9B3}" dt="2024-11-12T11:53:06.969" v="8"/>
        <pc:sldMkLst>
          <pc:docMk/>
          <pc:sldMk cId="3201712340" sldId="258"/>
        </pc:sldMkLst>
        <pc:graphicFrameChg chg="mod">
          <ac:chgData name="雄康 大野" userId="289040ba27705a35" providerId="LiveId" clId="{67119FF0-9104-4DDB-80D5-FE26F86DB9B3}" dt="2024-11-12T11:42:51.628" v="3"/>
          <ac:graphicFrameMkLst>
            <pc:docMk/>
            <pc:sldMk cId="3201712340" sldId="258"/>
            <ac:graphicFrameMk id="2" creationId="{D44CEAF4-56E1-466A-FC84-E21F57864C9D}"/>
          </ac:graphicFrameMkLst>
        </pc:graphicFrameChg>
        <pc:graphicFrameChg chg="mod">
          <ac:chgData name="雄康 大野" userId="289040ba27705a35" providerId="LiveId" clId="{67119FF0-9104-4DDB-80D5-FE26F86DB9B3}" dt="2024-11-12T11:43:11.412" v="7"/>
          <ac:graphicFrameMkLst>
            <pc:docMk/>
            <pc:sldMk cId="3201712340" sldId="258"/>
            <ac:graphicFrameMk id="3" creationId="{3851CF08-3D58-AE5A-F1C2-826B2F7C81C3}"/>
          </ac:graphicFrameMkLst>
        </pc:graphicFrameChg>
      </pc:sldChg>
    </pc:docChg>
  </pc:docChgLst>
  <pc:docChgLst>
    <pc:chgData name="雄康 大野" userId="289040ba27705a35" providerId="LiveId" clId="{B386BD37-085D-4477-904B-1156E63113D7}"/>
    <pc:docChg chg="undo custSel addSld delSld modSld">
      <pc:chgData name="雄康 大野" userId="289040ba27705a35" providerId="LiveId" clId="{B386BD37-085D-4477-904B-1156E63113D7}" dt="2024-07-30T13:56:59.669" v="888" actId="14734"/>
      <pc:docMkLst>
        <pc:docMk/>
      </pc:docMkLst>
      <pc:sldChg chg="del">
        <pc:chgData name="雄康 大野" userId="289040ba27705a35" providerId="LiveId" clId="{B386BD37-085D-4477-904B-1156E63113D7}" dt="2024-07-30T02:54:31.581" v="122" actId="47"/>
        <pc:sldMkLst>
          <pc:docMk/>
          <pc:sldMk cId="1480799046" sldId="257"/>
        </pc:sldMkLst>
      </pc:sldChg>
      <pc:sldChg chg="del">
        <pc:chgData name="雄康 大野" userId="289040ba27705a35" providerId="LiveId" clId="{B386BD37-085D-4477-904B-1156E63113D7}" dt="2024-07-30T02:54:30.859" v="121" actId="47"/>
        <pc:sldMkLst>
          <pc:docMk/>
          <pc:sldMk cId="3967253686" sldId="258"/>
        </pc:sldMkLst>
      </pc:sldChg>
      <pc:sldChg chg="addSp delSp modSp new mod">
        <pc:chgData name="雄康 大野" userId="289040ba27705a35" providerId="LiveId" clId="{B386BD37-085D-4477-904B-1156E63113D7}" dt="2024-07-30T13:55:12.316" v="881"/>
        <pc:sldMkLst>
          <pc:docMk/>
          <pc:sldMk cId="3092251034" sldId="259"/>
        </pc:sldMkLst>
        <pc:spChg chg="del">
          <ac:chgData name="雄康 大野" userId="289040ba27705a35" providerId="LiveId" clId="{B386BD37-085D-4477-904B-1156E63113D7}" dt="2024-07-29T13:44:08.832" v="1" actId="478"/>
          <ac:spMkLst>
            <pc:docMk/>
            <pc:sldMk cId="3092251034" sldId="259"/>
            <ac:spMk id="2" creationId="{49348D47-AC79-9151-9142-3F2402A97985}"/>
          </ac:spMkLst>
        </pc:spChg>
        <pc:spChg chg="del">
          <ac:chgData name="雄康 大野" userId="289040ba27705a35" providerId="LiveId" clId="{B386BD37-085D-4477-904B-1156E63113D7}" dt="2024-07-29T13:44:11.370" v="2" actId="478"/>
          <ac:spMkLst>
            <pc:docMk/>
            <pc:sldMk cId="3092251034" sldId="259"/>
            <ac:spMk id="3" creationId="{298E0BB6-CE32-0C2A-B4A3-DDC40CE29E2C}"/>
          </ac:spMkLst>
        </pc:spChg>
        <pc:spChg chg="add mod">
          <ac:chgData name="雄康 大野" userId="289040ba27705a35" providerId="LiveId" clId="{B386BD37-085D-4477-904B-1156E63113D7}" dt="2024-07-30T13:04:55.650" v="545" actId="14100"/>
          <ac:spMkLst>
            <pc:docMk/>
            <pc:sldMk cId="3092251034" sldId="259"/>
            <ac:spMk id="4" creationId="{A658390F-1A9D-E10B-3767-663B1E99886C}"/>
          </ac:spMkLst>
        </pc:spChg>
        <pc:spChg chg="add mod">
          <ac:chgData name="雄康 大野" userId="289040ba27705a35" providerId="LiveId" clId="{B386BD37-085D-4477-904B-1156E63113D7}" dt="2024-07-30T02:54:00.058" v="107" actId="1076"/>
          <ac:spMkLst>
            <pc:docMk/>
            <pc:sldMk cId="3092251034" sldId="259"/>
            <ac:spMk id="5" creationId="{FC38F542-2955-D241-B3FE-C076188842B5}"/>
          </ac:spMkLst>
        </pc:spChg>
        <pc:spChg chg="add mod">
          <ac:chgData name="雄康 大野" userId="289040ba27705a35" providerId="LiveId" clId="{B386BD37-085D-4477-904B-1156E63113D7}" dt="2024-07-30T02:54:16.058" v="120" actId="1035"/>
          <ac:spMkLst>
            <pc:docMk/>
            <pc:sldMk cId="3092251034" sldId="259"/>
            <ac:spMk id="6" creationId="{FB8B5A46-9885-2C61-FB49-6AEF8092A223}"/>
          </ac:spMkLst>
        </pc:spChg>
        <pc:graphicFrameChg chg="add mod">
          <ac:chgData name="雄康 大野" userId="289040ba27705a35" providerId="LiveId" clId="{B386BD37-085D-4477-904B-1156E63113D7}" dt="2024-07-30T02:58:11.651" v="265" actId="1036"/>
          <ac:graphicFrameMkLst>
            <pc:docMk/>
            <pc:sldMk cId="3092251034" sldId="259"/>
            <ac:graphicFrameMk id="2" creationId="{215DFE23-E669-4B1C-4F96-EDB4FE7D9E7C}"/>
          </ac:graphicFrameMkLst>
        </pc:graphicFrameChg>
        <pc:graphicFrameChg chg="add mod modGraphic">
          <ac:chgData name="雄康 大野" userId="289040ba27705a35" providerId="LiveId" clId="{B386BD37-085D-4477-904B-1156E63113D7}" dt="2024-07-30T13:55:12.316" v="881"/>
          <ac:graphicFrameMkLst>
            <pc:docMk/>
            <pc:sldMk cId="3092251034" sldId="259"/>
            <ac:graphicFrameMk id="3" creationId="{5EBD4749-247B-0BD1-04CD-EB5826A00B62}"/>
          </ac:graphicFrameMkLst>
        </pc:graphicFrameChg>
      </pc:sldChg>
      <pc:sldChg chg="addSp delSp modSp add mod">
        <pc:chgData name="雄康 大野" userId="289040ba27705a35" providerId="LiveId" clId="{B386BD37-085D-4477-904B-1156E63113D7}" dt="2024-07-30T13:55:23.063" v="882"/>
        <pc:sldMkLst>
          <pc:docMk/>
          <pc:sldMk cId="716265052" sldId="260"/>
        </pc:sldMkLst>
        <pc:spChg chg="mod">
          <ac:chgData name="雄康 大野" userId="289040ba27705a35" providerId="LiveId" clId="{B386BD37-085D-4477-904B-1156E63113D7}" dt="2024-07-30T13:04:40.551" v="543" actId="14100"/>
          <ac:spMkLst>
            <pc:docMk/>
            <pc:sldMk cId="716265052" sldId="260"/>
            <ac:spMk id="4" creationId="{A658390F-1A9D-E10B-3767-663B1E99886C}"/>
          </ac:spMkLst>
        </pc:spChg>
        <pc:graphicFrameChg chg="del">
          <ac:chgData name="雄康 大野" userId="289040ba27705a35" providerId="LiveId" clId="{B386BD37-085D-4477-904B-1156E63113D7}" dt="2024-07-30T02:55:06.857" v="124" actId="478"/>
          <ac:graphicFrameMkLst>
            <pc:docMk/>
            <pc:sldMk cId="716265052" sldId="260"/>
            <ac:graphicFrameMk id="2" creationId="{215DFE23-E669-4B1C-4F96-EDB4FE7D9E7C}"/>
          </ac:graphicFrameMkLst>
        </pc:graphicFrameChg>
        <pc:graphicFrameChg chg="mod modGraphic">
          <ac:chgData name="雄康 大野" userId="289040ba27705a35" providerId="LiveId" clId="{B386BD37-085D-4477-904B-1156E63113D7}" dt="2024-07-30T13:55:23.063" v="882"/>
          <ac:graphicFrameMkLst>
            <pc:docMk/>
            <pc:sldMk cId="716265052" sldId="260"/>
            <ac:graphicFrameMk id="3" creationId="{5EBD4749-247B-0BD1-04CD-EB5826A00B62}"/>
          </ac:graphicFrameMkLst>
        </pc:graphicFrameChg>
        <pc:graphicFrameChg chg="add mod">
          <ac:chgData name="雄康 大野" userId="289040ba27705a35" providerId="LiveId" clId="{B386BD37-085D-4477-904B-1156E63113D7}" dt="2024-07-30T02:57:49.651" v="248" actId="1035"/>
          <ac:graphicFrameMkLst>
            <pc:docMk/>
            <pc:sldMk cId="716265052" sldId="260"/>
            <ac:graphicFrameMk id="7" creationId="{F8986106-328D-79B7-BAB8-2EE68F2FC40A}"/>
          </ac:graphicFrameMkLst>
        </pc:graphicFrameChg>
      </pc:sldChg>
      <pc:sldChg chg="addSp delSp modSp add mod">
        <pc:chgData name="雄康 大野" userId="289040ba27705a35" providerId="LiveId" clId="{B386BD37-085D-4477-904B-1156E63113D7}" dt="2024-07-30T13:55:34.510" v="883"/>
        <pc:sldMkLst>
          <pc:docMk/>
          <pc:sldMk cId="1407430057" sldId="261"/>
        </pc:sldMkLst>
        <pc:spChg chg="mod">
          <ac:chgData name="雄康 大野" userId="289040ba27705a35" providerId="LiveId" clId="{B386BD37-085D-4477-904B-1156E63113D7}" dt="2024-07-30T13:05:09.966" v="547" actId="14100"/>
          <ac:spMkLst>
            <pc:docMk/>
            <pc:sldMk cId="1407430057" sldId="261"/>
            <ac:spMk id="4" creationId="{A658390F-1A9D-E10B-3767-663B1E99886C}"/>
          </ac:spMkLst>
        </pc:spChg>
        <pc:graphicFrameChg chg="add mod">
          <ac:chgData name="雄康 大野" userId="289040ba27705a35" providerId="LiveId" clId="{B386BD37-085D-4477-904B-1156E63113D7}" dt="2024-07-30T12:04:59.170" v="296" actId="1076"/>
          <ac:graphicFrameMkLst>
            <pc:docMk/>
            <pc:sldMk cId="1407430057" sldId="261"/>
            <ac:graphicFrameMk id="2" creationId="{EA696120-EA6F-715E-9876-562C70D41F5D}"/>
          </ac:graphicFrameMkLst>
        </pc:graphicFrameChg>
        <pc:graphicFrameChg chg="mod modGraphic">
          <ac:chgData name="雄康 大野" userId="289040ba27705a35" providerId="LiveId" clId="{B386BD37-085D-4477-904B-1156E63113D7}" dt="2024-07-30T13:55:34.510" v="883"/>
          <ac:graphicFrameMkLst>
            <pc:docMk/>
            <pc:sldMk cId="1407430057" sldId="261"/>
            <ac:graphicFrameMk id="3" creationId="{5EBD4749-247B-0BD1-04CD-EB5826A00B62}"/>
          </ac:graphicFrameMkLst>
        </pc:graphicFrameChg>
        <pc:graphicFrameChg chg="del">
          <ac:chgData name="雄康 大野" userId="289040ba27705a35" providerId="LiveId" clId="{B386BD37-085D-4477-904B-1156E63113D7}" dt="2024-07-30T02:56:50.834" v="166" actId="478"/>
          <ac:graphicFrameMkLst>
            <pc:docMk/>
            <pc:sldMk cId="1407430057" sldId="261"/>
            <ac:graphicFrameMk id="7" creationId="{F8986106-328D-79B7-BAB8-2EE68F2FC40A}"/>
          </ac:graphicFrameMkLst>
        </pc:graphicFrameChg>
      </pc:sldChg>
      <pc:sldChg chg="addSp delSp modSp add mod">
        <pc:chgData name="雄康 大野" userId="289040ba27705a35" providerId="LiveId" clId="{B386BD37-085D-4477-904B-1156E63113D7}" dt="2024-07-30T13:55:51.285" v="884"/>
        <pc:sldMkLst>
          <pc:docMk/>
          <pc:sldMk cId="1896302480" sldId="262"/>
        </pc:sldMkLst>
        <pc:spChg chg="mod">
          <ac:chgData name="雄康 大野" userId="289040ba27705a35" providerId="LiveId" clId="{B386BD37-085D-4477-904B-1156E63113D7}" dt="2024-07-30T13:05:25.582" v="549" actId="14100"/>
          <ac:spMkLst>
            <pc:docMk/>
            <pc:sldMk cId="1896302480" sldId="262"/>
            <ac:spMk id="4" creationId="{A658390F-1A9D-E10B-3767-663B1E99886C}"/>
          </ac:spMkLst>
        </pc:spChg>
        <pc:graphicFrameChg chg="del">
          <ac:chgData name="雄康 大野" userId="289040ba27705a35" providerId="LiveId" clId="{B386BD37-085D-4477-904B-1156E63113D7}" dt="2024-07-30T12:03:55.076" v="280" actId="478"/>
          <ac:graphicFrameMkLst>
            <pc:docMk/>
            <pc:sldMk cId="1896302480" sldId="262"/>
            <ac:graphicFrameMk id="2" creationId="{EA696120-EA6F-715E-9876-562C70D41F5D}"/>
          </ac:graphicFrameMkLst>
        </pc:graphicFrameChg>
        <pc:graphicFrameChg chg="mod modGraphic">
          <ac:chgData name="雄康 大野" userId="289040ba27705a35" providerId="LiveId" clId="{B386BD37-085D-4477-904B-1156E63113D7}" dt="2024-07-30T13:55:51.285" v="884"/>
          <ac:graphicFrameMkLst>
            <pc:docMk/>
            <pc:sldMk cId="1896302480" sldId="262"/>
            <ac:graphicFrameMk id="3" creationId="{5EBD4749-247B-0BD1-04CD-EB5826A00B62}"/>
          </ac:graphicFrameMkLst>
        </pc:graphicFrameChg>
        <pc:graphicFrameChg chg="add mod">
          <ac:chgData name="雄康 大野" userId="289040ba27705a35" providerId="LiveId" clId="{B386BD37-085D-4477-904B-1156E63113D7}" dt="2024-07-30T12:05:20.944" v="317" actId="1036"/>
          <ac:graphicFrameMkLst>
            <pc:docMk/>
            <pc:sldMk cId="1896302480" sldId="262"/>
            <ac:graphicFrameMk id="7" creationId="{D14478D4-E6C5-C657-17D3-91F56BCB75F6}"/>
          </ac:graphicFrameMkLst>
        </pc:graphicFrameChg>
      </pc:sldChg>
      <pc:sldChg chg="addSp delSp modSp add mod">
        <pc:chgData name="雄康 大野" userId="289040ba27705a35" providerId="LiveId" clId="{B386BD37-085D-4477-904B-1156E63113D7}" dt="2024-07-30T13:56:59.669" v="888" actId="14734"/>
        <pc:sldMkLst>
          <pc:docMk/>
          <pc:sldMk cId="474960916" sldId="263"/>
        </pc:sldMkLst>
        <pc:spChg chg="mod">
          <ac:chgData name="雄康 大野" userId="289040ba27705a35" providerId="LiveId" clId="{B386BD37-085D-4477-904B-1156E63113D7}" dt="2024-07-30T13:05:36.563" v="551" actId="14100"/>
          <ac:spMkLst>
            <pc:docMk/>
            <pc:sldMk cId="474960916" sldId="263"/>
            <ac:spMk id="4" creationId="{A658390F-1A9D-E10B-3767-663B1E99886C}"/>
          </ac:spMkLst>
        </pc:spChg>
        <pc:graphicFrameChg chg="add mod">
          <ac:chgData name="雄康 大野" userId="289040ba27705a35" providerId="LiveId" clId="{B386BD37-085D-4477-904B-1156E63113D7}" dt="2024-07-30T12:06:36.716" v="353" actId="1035"/>
          <ac:graphicFrameMkLst>
            <pc:docMk/>
            <pc:sldMk cId="474960916" sldId="263"/>
            <ac:graphicFrameMk id="2" creationId="{F7045346-BA9F-7E25-6CF8-6C7BE6DD92F5}"/>
          </ac:graphicFrameMkLst>
        </pc:graphicFrameChg>
        <pc:graphicFrameChg chg="mod modGraphic">
          <ac:chgData name="雄康 大野" userId="289040ba27705a35" providerId="LiveId" clId="{B386BD37-085D-4477-904B-1156E63113D7}" dt="2024-07-30T13:56:59.669" v="888" actId="14734"/>
          <ac:graphicFrameMkLst>
            <pc:docMk/>
            <pc:sldMk cId="474960916" sldId="263"/>
            <ac:graphicFrameMk id="3" creationId="{5EBD4749-247B-0BD1-04CD-EB5826A00B62}"/>
          </ac:graphicFrameMkLst>
        </pc:graphicFrameChg>
        <pc:graphicFrameChg chg="del">
          <ac:chgData name="雄康 大野" userId="289040ba27705a35" providerId="LiveId" clId="{B386BD37-085D-4477-904B-1156E63113D7}" dt="2024-07-30T12:05:48.825" v="328" actId="478"/>
          <ac:graphicFrameMkLst>
            <pc:docMk/>
            <pc:sldMk cId="474960916" sldId="263"/>
            <ac:graphicFrameMk id="7" creationId="{D14478D4-E6C5-C657-17D3-91F56BCB75F6}"/>
          </ac:graphicFrameMkLst>
        </pc:graphicFrameChg>
      </pc:sldChg>
      <pc:sldChg chg="addSp delSp modSp add mod">
        <pc:chgData name="雄康 大野" userId="289040ba27705a35" providerId="LiveId" clId="{B386BD37-085D-4477-904B-1156E63113D7}" dt="2024-07-30T13:56:42.531" v="886"/>
        <pc:sldMkLst>
          <pc:docMk/>
          <pc:sldMk cId="3195160274" sldId="264"/>
        </pc:sldMkLst>
        <pc:spChg chg="mod">
          <ac:chgData name="雄康 大野" userId="289040ba27705a35" providerId="LiveId" clId="{B386BD37-085D-4477-904B-1156E63113D7}" dt="2024-07-30T13:05:48" v="553" actId="14100"/>
          <ac:spMkLst>
            <pc:docMk/>
            <pc:sldMk cId="3195160274" sldId="264"/>
            <ac:spMk id="4" creationId="{A658390F-1A9D-E10B-3767-663B1E99886C}"/>
          </ac:spMkLst>
        </pc:spChg>
        <pc:graphicFrameChg chg="del">
          <ac:chgData name="雄康 大野" userId="289040ba27705a35" providerId="LiveId" clId="{B386BD37-085D-4477-904B-1156E63113D7}" dt="2024-07-30T12:07:01.670" v="355" actId="478"/>
          <ac:graphicFrameMkLst>
            <pc:docMk/>
            <pc:sldMk cId="3195160274" sldId="264"/>
            <ac:graphicFrameMk id="2" creationId="{F7045346-BA9F-7E25-6CF8-6C7BE6DD92F5}"/>
          </ac:graphicFrameMkLst>
        </pc:graphicFrameChg>
        <pc:graphicFrameChg chg="mod modGraphic">
          <ac:chgData name="雄康 大野" userId="289040ba27705a35" providerId="LiveId" clId="{B386BD37-085D-4477-904B-1156E63113D7}" dt="2024-07-30T13:56:42.531" v="886"/>
          <ac:graphicFrameMkLst>
            <pc:docMk/>
            <pc:sldMk cId="3195160274" sldId="264"/>
            <ac:graphicFrameMk id="3" creationId="{5EBD4749-247B-0BD1-04CD-EB5826A00B62}"/>
          </ac:graphicFrameMkLst>
        </pc:graphicFrameChg>
        <pc:graphicFrameChg chg="add mod">
          <ac:chgData name="雄康 大野" userId="289040ba27705a35" providerId="LiveId" clId="{B386BD37-085D-4477-904B-1156E63113D7}" dt="2024-07-30T12:07:43.160" v="373" actId="1035"/>
          <ac:graphicFrameMkLst>
            <pc:docMk/>
            <pc:sldMk cId="3195160274" sldId="264"/>
            <ac:graphicFrameMk id="7" creationId="{5F43EC09-8CE5-BC92-794A-E8E71D403B90}"/>
          </ac:graphicFrameMkLst>
        </pc:graphicFrameChg>
      </pc:sldChg>
    </pc:docChg>
  </pc:docChgLst>
  <pc:docChgLst>
    <pc:chgData name="雄康 大野" userId="289040ba27705a35" providerId="LiveId" clId="{7AEAB500-92AF-41C2-A510-78B7DED58EBF}"/>
    <pc:docChg chg="undo custSel addSld delSld modSld">
      <pc:chgData name="雄康 大野" userId="289040ba27705a35" providerId="LiveId" clId="{7AEAB500-92AF-41C2-A510-78B7DED58EBF}" dt="2024-07-31T07:58:58.351" v="328" actId="1076"/>
      <pc:docMkLst>
        <pc:docMk/>
      </pc:docMkLst>
      <pc:sldChg chg="addSp delSp modSp new mod">
        <pc:chgData name="雄康 大野" userId="289040ba27705a35" providerId="LiveId" clId="{7AEAB500-92AF-41C2-A510-78B7DED58EBF}" dt="2024-07-31T07:58:58.351" v="328" actId="1076"/>
        <pc:sldMkLst>
          <pc:docMk/>
          <pc:sldMk cId="1251099873" sldId="256"/>
        </pc:sldMkLst>
        <pc:spChg chg="del">
          <ac:chgData name="雄康 大野" userId="289040ba27705a35" providerId="LiveId" clId="{7AEAB500-92AF-41C2-A510-78B7DED58EBF}" dt="2024-07-31T07:11:42.394" v="4" actId="478"/>
          <ac:spMkLst>
            <pc:docMk/>
            <pc:sldMk cId="1251099873" sldId="256"/>
            <ac:spMk id="2" creationId="{E0103A93-8C11-3706-0819-09B73D513380}"/>
          </ac:spMkLst>
        </pc:spChg>
        <pc:spChg chg="del">
          <ac:chgData name="雄康 大野" userId="289040ba27705a35" providerId="LiveId" clId="{7AEAB500-92AF-41C2-A510-78B7DED58EBF}" dt="2024-07-31T07:11:43.952" v="5" actId="478"/>
          <ac:spMkLst>
            <pc:docMk/>
            <pc:sldMk cId="1251099873" sldId="256"/>
            <ac:spMk id="3" creationId="{3CFACEDA-0B90-2D16-1938-CA167C9EE572}"/>
          </ac:spMkLst>
        </pc:spChg>
        <pc:spChg chg="add mod">
          <ac:chgData name="雄康 大野" userId="289040ba27705a35" providerId="LiveId" clId="{7AEAB500-92AF-41C2-A510-78B7DED58EBF}" dt="2024-07-31T07:21:41.602" v="219" actId="1037"/>
          <ac:spMkLst>
            <pc:docMk/>
            <pc:sldMk cId="1251099873" sldId="256"/>
            <ac:spMk id="7" creationId="{13D4A0DC-A832-A0D0-05E9-DA55C54B266E}"/>
          </ac:spMkLst>
        </pc:spChg>
        <pc:spChg chg="add mod">
          <ac:chgData name="雄康 大野" userId="289040ba27705a35" providerId="LiveId" clId="{7AEAB500-92AF-41C2-A510-78B7DED58EBF}" dt="2024-07-31T07:31:58.718" v="250" actId="20577"/>
          <ac:spMkLst>
            <pc:docMk/>
            <pc:sldMk cId="1251099873" sldId="256"/>
            <ac:spMk id="8" creationId="{A5912FA1-86E7-047A-2857-EE8852E9B190}"/>
          </ac:spMkLst>
        </pc:spChg>
        <pc:spChg chg="add mod">
          <ac:chgData name="雄康 大野" userId="289040ba27705a35" providerId="LiveId" clId="{7AEAB500-92AF-41C2-A510-78B7DED58EBF}" dt="2024-07-31T07:37:15.520" v="260" actId="20577"/>
          <ac:spMkLst>
            <pc:docMk/>
            <pc:sldMk cId="1251099873" sldId="256"/>
            <ac:spMk id="12" creationId="{10CAAB8C-00E5-370A-C099-2BCFAAB7B89F}"/>
          </ac:spMkLst>
        </pc:spChg>
        <pc:spChg chg="add mod">
          <ac:chgData name="雄康 大野" userId="289040ba27705a35" providerId="LiveId" clId="{7AEAB500-92AF-41C2-A510-78B7DED58EBF}" dt="2024-07-31T07:37:57.244" v="274" actId="20577"/>
          <ac:spMkLst>
            <pc:docMk/>
            <pc:sldMk cId="1251099873" sldId="256"/>
            <ac:spMk id="13" creationId="{6096C029-EE92-CBD9-F0CC-7586C46FCAF7}"/>
          </ac:spMkLst>
        </pc:spChg>
        <pc:spChg chg="add mod">
          <ac:chgData name="雄康 大野" userId="289040ba27705a35" providerId="LiveId" clId="{7AEAB500-92AF-41C2-A510-78B7DED58EBF}" dt="2024-07-31T07:38:35.043" v="275"/>
          <ac:spMkLst>
            <pc:docMk/>
            <pc:sldMk cId="1251099873" sldId="256"/>
            <ac:spMk id="14" creationId="{33E01427-2796-553F-A879-4012030A3D9C}"/>
          </ac:spMkLst>
        </pc:spChg>
        <pc:spChg chg="add mod">
          <ac:chgData name="雄康 大野" userId="289040ba27705a35" providerId="LiveId" clId="{7AEAB500-92AF-41C2-A510-78B7DED58EBF}" dt="2024-07-31T07:38:47.509" v="276"/>
          <ac:spMkLst>
            <pc:docMk/>
            <pc:sldMk cId="1251099873" sldId="256"/>
            <ac:spMk id="15" creationId="{49A8C392-2B48-B25C-4286-B1D74625E380}"/>
          </ac:spMkLst>
        </pc:spChg>
        <pc:spChg chg="add mod">
          <ac:chgData name="雄康 大野" userId="289040ba27705a35" providerId="LiveId" clId="{7AEAB500-92AF-41C2-A510-78B7DED58EBF}" dt="2024-07-31T07:39:03.649" v="277"/>
          <ac:spMkLst>
            <pc:docMk/>
            <pc:sldMk cId="1251099873" sldId="256"/>
            <ac:spMk id="16" creationId="{DF0871CA-432A-6794-0B7A-706DC4CBED91}"/>
          </ac:spMkLst>
        </pc:spChg>
        <pc:spChg chg="add mod">
          <ac:chgData name="雄康 大野" userId="289040ba27705a35" providerId="LiveId" clId="{7AEAB500-92AF-41C2-A510-78B7DED58EBF}" dt="2024-07-31T07:39:26.436" v="278"/>
          <ac:spMkLst>
            <pc:docMk/>
            <pc:sldMk cId="1251099873" sldId="256"/>
            <ac:spMk id="17" creationId="{29060193-F586-D5CC-A900-289F9B146903}"/>
          </ac:spMkLst>
        </pc:spChg>
        <pc:spChg chg="add mod">
          <ac:chgData name="雄康 大野" userId="289040ba27705a35" providerId="LiveId" clId="{7AEAB500-92AF-41C2-A510-78B7DED58EBF}" dt="2024-07-31T07:39:35.982" v="279"/>
          <ac:spMkLst>
            <pc:docMk/>
            <pc:sldMk cId="1251099873" sldId="256"/>
            <ac:spMk id="18" creationId="{105E6E26-1515-F49B-E75C-D74F0889C90F}"/>
          </ac:spMkLst>
        </pc:spChg>
        <pc:spChg chg="add mod">
          <ac:chgData name="雄康 大野" userId="289040ba27705a35" providerId="LiveId" clId="{7AEAB500-92AF-41C2-A510-78B7DED58EBF}" dt="2024-07-31T07:39:49.831" v="280"/>
          <ac:spMkLst>
            <pc:docMk/>
            <pc:sldMk cId="1251099873" sldId="256"/>
            <ac:spMk id="19" creationId="{AF6F46B1-B30F-6B42-4728-3C8BB4882198}"/>
          </ac:spMkLst>
        </pc:spChg>
        <pc:spChg chg="add mod">
          <ac:chgData name="雄康 大野" userId="289040ba27705a35" providerId="LiveId" clId="{7AEAB500-92AF-41C2-A510-78B7DED58EBF}" dt="2024-07-31T07:41:56.216" v="296" actId="6549"/>
          <ac:spMkLst>
            <pc:docMk/>
            <pc:sldMk cId="1251099873" sldId="256"/>
            <ac:spMk id="20" creationId="{D00D9B2B-C895-6791-ACA1-CDBB5BB5F319}"/>
          </ac:spMkLst>
        </pc:spChg>
        <pc:spChg chg="add mod">
          <ac:chgData name="雄康 大野" userId="289040ba27705a35" providerId="LiveId" clId="{7AEAB500-92AF-41C2-A510-78B7DED58EBF}" dt="2024-07-31T07:58:58.351" v="328" actId="1076"/>
          <ac:spMkLst>
            <pc:docMk/>
            <pc:sldMk cId="1251099873" sldId="256"/>
            <ac:spMk id="21" creationId="{127459E3-D2DC-370C-5846-7C2E665AD9B7}"/>
          </ac:spMkLst>
        </pc:spChg>
        <pc:spChg chg="add mod">
          <ac:chgData name="雄康 大野" userId="289040ba27705a35" providerId="LiveId" clId="{7AEAB500-92AF-41C2-A510-78B7DED58EBF}" dt="2024-07-31T07:58:42.055" v="322" actId="6549"/>
          <ac:spMkLst>
            <pc:docMk/>
            <pc:sldMk cId="1251099873" sldId="256"/>
            <ac:spMk id="22" creationId="{56E62565-C254-3F26-4CFB-807024A66FF7}"/>
          </ac:spMkLst>
        </pc:spChg>
        <pc:spChg chg="add mod">
          <ac:chgData name="雄康 大野" userId="289040ba27705a35" providerId="LiveId" clId="{7AEAB500-92AF-41C2-A510-78B7DED58EBF}" dt="2024-07-31T07:58:50.934" v="327" actId="6549"/>
          <ac:spMkLst>
            <pc:docMk/>
            <pc:sldMk cId="1251099873" sldId="256"/>
            <ac:spMk id="23" creationId="{D56D9057-8E99-A319-F1D1-893602AE7E3E}"/>
          </ac:spMkLst>
        </pc:spChg>
        <pc:graphicFrameChg chg="add del mod">
          <ac:chgData name="雄康 大野" userId="289040ba27705a35" providerId="LiveId" clId="{7AEAB500-92AF-41C2-A510-78B7DED58EBF}" dt="2024-07-31T06:53:26.179" v="3" actId="478"/>
          <ac:graphicFrameMkLst>
            <pc:docMk/>
            <pc:sldMk cId="1251099873" sldId="256"/>
            <ac:graphicFrameMk id="4" creationId="{0B87F2AD-A4BC-782E-53F4-DF23198FFEF0}"/>
          </ac:graphicFrameMkLst>
        </pc:graphicFrameChg>
        <pc:graphicFrameChg chg="add mod">
          <ac:chgData name="雄康 大野" userId="289040ba27705a35" providerId="LiveId" clId="{7AEAB500-92AF-41C2-A510-78B7DED58EBF}" dt="2024-07-31T07:20:47.882" v="106" actId="1038"/>
          <ac:graphicFrameMkLst>
            <pc:docMk/>
            <pc:sldMk cId="1251099873" sldId="256"/>
            <ac:graphicFrameMk id="5" creationId="{2E66DA0E-104E-D467-48C8-3C2CB7295021}"/>
          </ac:graphicFrameMkLst>
        </pc:graphicFrameChg>
        <pc:graphicFrameChg chg="add mod">
          <ac:chgData name="雄康 大野" userId="289040ba27705a35" providerId="LiveId" clId="{7AEAB500-92AF-41C2-A510-78B7DED58EBF}" dt="2024-07-31T07:40:57.027" v="287" actId="1076"/>
          <ac:graphicFrameMkLst>
            <pc:docMk/>
            <pc:sldMk cId="1251099873" sldId="256"/>
            <ac:graphicFrameMk id="6" creationId="{E322FEC5-0116-9D7F-3A0E-30A7FB2F5520}"/>
          </ac:graphicFrameMkLst>
        </pc:graphicFrameChg>
        <pc:graphicFrameChg chg="add del mod">
          <ac:chgData name="雄康 大野" userId="289040ba27705a35" providerId="LiveId" clId="{7AEAB500-92AF-41C2-A510-78B7DED58EBF}" dt="2024-07-31T07:28:52.074" v="226" actId="478"/>
          <ac:graphicFrameMkLst>
            <pc:docMk/>
            <pc:sldMk cId="1251099873" sldId="256"/>
            <ac:graphicFrameMk id="9" creationId="{0076D34A-ED06-0A85-FDC9-4DBEA51549DB}"/>
          </ac:graphicFrameMkLst>
        </pc:graphicFrameChg>
        <pc:graphicFrameChg chg="add mod">
          <ac:chgData name="雄康 大野" userId="289040ba27705a35" providerId="LiveId" clId="{7AEAB500-92AF-41C2-A510-78B7DED58EBF}" dt="2024-07-31T07:29:07.403" v="231" actId="1076"/>
          <ac:graphicFrameMkLst>
            <pc:docMk/>
            <pc:sldMk cId="1251099873" sldId="256"/>
            <ac:graphicFrameMk id="10" creationId="{C19522A4-860A-EF83-752C-F0A35594A7B5}"/>
          </ac:graphicFrameMkLst>
        </pc:graphicFrameChg>
        <pc:graphicFrameChg chg="add mod">
          <ac:chgData name="雄康 大野" userId="289040ba27705a35" providerId="LiveId" clId="{7AEAB500-92AF-41C2-A510-78B7DED58EBF}" dt="2024-07-31T07:30:01.583" v="238" actId="1076"/>
          <ac:graphicFrameMkLst>
            <pc:docMk/>
            <pc:sldMk cId="1251099873" sldId="256"/>
            <ac:graphicFrameMk id="11" creationId="{3C6299A0-9E3B-E66E-80AC-9F546E21461A}"/>
          </ac:graphicFrameMkLst>
        </pc:graphicFrameChg>
      </pc:sldChg>
      <pc:sldChg chg="del">
        <pc:chgData name="雄康 大野" userId="289040ba27705a35" providerId="LiveId" clId="{7AEAB500-92AF-41C2-A510-78B7DED58EBF}" dt="2024-07-31T06:53:06.263" v="0" actId="47"/>
        <pc:sldMkLst>
          <pc:docMk/>
          <pc:sldMk cId="3092251034" sldId="259"/>
        </pc:sldMkLst>
      </pc:sldChg>
      <pc:sldChg chg="del">
        <pc:chgData name="雄康 大野" userId="289040ba27705a35" providerId="LiveId" clId="{7AEAB500-92AF-41C2-A510-78B7DED58EBF}" dt="2024-07-31T06:53:06.263" v="0" actId="47"/>
        <pc:sldMkLst>
          <pc:docMk/>
          <pc:sldMk cId="716265052" sldId="260"/>
        </pc:sldMkLst>
      </pc:sldChg>
      <pc:sldChg chg="del">
        <pc:chgData name="雄康 大野" userId="289040ba27705a35" providerId="LiveId" clId="{7AEAB500-92AF-41C2-A510-78B7DED58EBF}" dt="2024-07-31T06:53:06.263" v="0" actId="47"/>
        <pc:sldMkLst>
          <pc:docMk/>
          <pc:sldMk cId="1407430057" sldId="261"/>
        </pc:sldMkLst>
      </pc:sldChg>
      <pc:sldChg chg="del">
        <pc:chgData name="雄康 大野" userId="289040ba27705a35" providerId="LiveId" clId="{7AEAB500-92AF-41C2-A510-78B7DED58EBF}" dt="2024-07-31T06:53:06.263" v="0" actId="47"/>
        <pc:sldMkLst>
          <pc:docMk/>
          <pc:sldMk cId="1896302480" sldId="262"/>
        </pc:sldMkLst>
      </pc:sldChg>
      <pc:sldChg chg="del">
        <pc:chgData name="雄康 大野" userId="289040ba27705a35" providerId="LiveId" clId="{7AEAB500-92AF-41C2-A510-78B7DED58EBF}" dt="2024-07-31T06:53:06.263" v="0" actId="47"/>
        <pc:sldMkLst>
          <pc:docMk/>
          <pc:sldMk cId="474960916" sldId="263"/>
        </pc:sldMkLst>
      </pc:sldChg>
      <pc:sldChg chg="del">
        <pc:chgData name="雄康 大野" userId="289040ba27705a35" providerId="LiveId" clId="{7AEAB500-92AF-41C2-A510-78B7DED58EBF}" dt="2024-07-31T06:53:06.263" v="0" actId="47"/>
        <pc:sldMkLst>
          <pc:docMk/>
          <pc:sldMk cId="3195160274" sldId="264"/>
        </pc:sldMkLst>
      </pc:sldChg>
    </pc:docChg>
  </pc:docChgLst>
  <pc:docChgLst>
    <pc:chgData name="雄康 大野" userId="289040ba27705a35" providerId="LiveId" clId="{79D7336E-6AC7-4D52-9A0E-E41A0F485719}"/>
    <pc:docChg chg="undo custSel addSld delSld modSld sldOrd">
      <pc:chgData name="雄康 大野" userId="289040ba27705a35" providerId="LiveId" clId="{79D7336E-6AC7-4D52-9A0E-E41A0F485719}" dt="2024-10-28T22:56:37.128" v="192" actId="6549"/>
      <pc:docMkLst>
        <pc:docMk/>
      </pc:docMkLst>
      <pc:sldChg chg="modSp del ord modNotesTx">
        <pc:chgData name="雄康 大野" userId="289040ba27705a35" providerId="LiveId" clId="{79D7336E-6AC7-4D52-9A0E-E41A0F485719}" dt="2024-10-17T05:25:42.346" v="149" actId="47"/>
        <pc:sldMkLst>
          <pc:docMk/>
          <pc:sldMk cId="1251099873" sldId="256"/>
        </pc:sldMkLst>
        <pc:graphicFrameChg chg="mod">
          <ac:chgData name="雄康 大野" userId="289040ba27705a35" providerId="LiveId" clId="{79D7336E-6AC7-4D52-9A0E-E41A0F485719}" dt="2024-09-22T00:01:54.852" v="3"/>
          <ac:graphicFrameMkLst>
            <pc:docMk/>
            <pc:sldMk cId="1251099873" sldId="256"/>
            <ac:graphicFrameMk id="10" creationId="{C19522A4-860A-EF83-752C-F0A35594A7B5}"/>
          </ac:graphicFrameMkLst>
        </pc:graphicFrameChg>
      </pc:sldChg>
      <pc:sldChg chg="new del">
        <pc:chgData name="雄康 大野" userId="289040ba27705a35" providerId="LiveId" clId="{79D7336E-6AC7-4D52-9A0E-E41A0F485719}" dt="2024-09-23T00:34:52.506" v="47" actId="47"/>
        <pc:sldMkLst>
          <pc:docMk/>
          <pc:sldMk cId="3122027931" sldId="257"/>
        </pc:sldMkLst>
      </pc:sldChg>
      <pc:sldChg chg="addSp delSp modSp add mod modNotesTx">
        <pc:chgData name="雄康 大野" userId="289040ba27705a35" providerId="LiveId" clId="{79D7336E-6AC7-4D52-9A0E-E41A0F485719}" dt="2024-10-28T22:56:37.128" v="192" actId="6549"/>
        <pc:sldMkLst>
          <pc:docMk/>
          <pc:sldMk cId="3201712340" sldId="258"/>
        </pc:sldMkLst>
        <pc:spChg chg="mod">
          <ac:chgData name="雄康 大野" userId="289040ba27705a35" providerId="LiveId" clId="{79D7336E-6AC7-4D52-9A0E-E41A0F485719}" dt="2024-10-18T08:19:58.420" v="157" actId="207"/>
          <ac:spMkLst>
            <pc:docMk/>
            <pc:sldMk cId="3201712340" sldId="258"/>
            <ac:spMk id="7" creationId="{13D4A0DC-A832-A0D0-05E9-DA55C54B266E}"/>
          </ac:spMkLst>
        </pc:spChg>
        <pc:spChg chg="mod">
          <ac:chgData name="雄康 大野" userId="289040ba27705a35" providerId="LiveId" clId="{79D7336E-6AC7-4D52-9A0E-E41A0F485719}" dt="2024-10-18T08:20:16.480" v="160" actId="20577"/>
          <ac:spMkLst>
            <pc:docMk/>
            <pc:sldMk cId="3201712340" sldId="258"/>
            <ac:spMk id="8" creationId="{A5912FA1-86E7-047A-2857-EE8852E9B190}"/>
          </ac:spMkLst>
        </pc:spChg>
        <pc:spChg chg="mod">
          <ac:chgData name="雄康 大野" userId="289040ba27705a35" providerId="LiveId" clId="{79D7336E-6AC7-4D52-9A0E-E41A0F485719}" dt="2024-10-18T08:20:39.053" v="164" actId="20577"/>
          <ac:spMkLst>
            <pc:docMk/>
            <pc:sldMk cId="3201712340" sldId="258"/>
            <ac:spMk id="12" creationId="{10CAAB8C-00E5-370A-C099-2BCFAAB7B89F}"/>
          </ac:spMkLst>
        </pc:spChg>
        <pc:spChg chg="mod">
          <ac:chgData name="雄康 大野" userId="289040ba27705a35" providerId="LiveId" clId="{79D7336E-6AC7-4D52-9A0E-E41A0F485719}" dt="2024-10-18T08:20:48.356" v="190" actId="1037"/>
          <ac:spMkLst>
            <pc:docMk/>
            <pc:sldMk cId="3201712340" sldId="258"/>
            <ac:spMk id="13" creationId="{6096C029-EE92-CBD9-F0CC-7586C46FCAF7}"/>
          </ac:spMkLst>
        </pc:spChg>
        <pc:spChg chg="mod">
          <ac:chgData name="雄康 大野" userId="289040ba27705a35" providerId="LiveId" clId="{79D7336E-6AC7-4D52-9A0E-E41A0F485719}" dt="2024-09-23T00:33:21.817" v="30" actId="1076"/>
          <ac:spMkLst>
            <pc:docMk/>
            <pc:sldMk cId="3201712340" sldId="258"/>
            <ac:spMk id="20" creationId="{D00D9B2B-C895-6791-ACA1-CDBB5BB5F319}"/>
          </ac:spMkLst>
        </pc:spChg>
        <pc:spChg chg="mod">
          <ac:chgData name="雄康 大野" userId="289040ba27705a35" providerId="LiveId" clId="{79D7336E-6AC7-4D52-9A0E-E41A0F485719}" dt="2024-09-23T00:34:27.706" v="38" actId="1076"/>
          <ac:spMkLst>
            <pc:docMk/>
            <pc:sldMk cId="3201712340" sldId="258"/>
            <ac:spMk id="21" creationId="{127459E3-D2DC-370C-5846-7C2E665AD9B7}"/>
          </ac:spMkLst>
        </pc:spChg>
        <pc:graphicFrameChg chg="add mod">
          <ac:chgData name="雄康 大野" userId="289040ba27705a35" providerId="LiveId" clId="{79D7336E-6AC7-4D52-9A0E-E41A0F485719}" dt="2024-09-23T00:33:15.267" v="29" actId="1076"/>
          <ac:graphicFrameMkLst>
            <pc:docMk/>
            <pc:sldMk cId="3201712340" sldId="258"/>
            <ac:graphicFrameMk id="2" creationId="{D44CEAF4-56E1-466A-FC84-E21F57864C9D}"/>
          </ac:graphicFrameMkLst>
        </pc:graphicFrameChg>
        <pc:graphicFrameChg chg="add mod">
          <ac:chgData name="雄康 大野" userId="289040ba27705a35" providerId="LiveId" clId="{79D7336E-6AC7-4D52-9A0E-E41A0F485719}" dt="2024-09-23T00:34:18.134" v="37" actId="1076"/>
          <ac:graphicFrameMkLst>
            <pc:docMk/>
            <pc:sldMk cId="3201712340" sldId="258"/>
            <ac:graphicFrameMk id="3" creationId="{3851CF08-3D58-AE5A-F1C2-826B2F7C81C3}"/>
          </ac:graphicFrameMkLst>
        </pc:graphicFrameChg>
        <pc:graphicFrameChg chg="add mod">
          <ac:chgData name="雄康 大野" userId="289040ba27705a35" providerId="LiveId" clId="{79D7336E-6AC7-4D52-9A0E-E41A0F485719}" dt="2024-09-23T00:35:52.570" v="56" actId="14100"/>
          <ac:graphicFrameMkLst>
            <pc:docMk/>
            <pc:sldMk cId="3201712340" sldId="258"/>
            <ac:graphicFrameMk id="4" creationId="{E0B9CCB5-A00E-7E6E-8D14-532D27C3F79F}"/>
          </ac:graphicFrameMkLst>
        </pc:graphicFrameChg>
        <pc:graphicFrameChg chg="del">
          <ac:chgData name="雄康 大野" userId="289040ba27705a35" providerId="LiveId" clId="{79D7336E-6AC7-4D52-9A0E-E41A0F485719}" dt="2024-09-23T00:31:24.848" v="10" actId="478"/>
          <ac:graphicFrameMkLst>
            <pc:docMk/>
            <pc:sldMk cId="3201712340" sldId="258"/>
            <ac:graphicFrameMk id="5" creationId="{2E66DA0E-104E-D467-48C8-3C2CB7295021}"/>
          </ac:graphicFrameMkLst>
        </pc:graphicFrameChg>
        <pc:graphicFrameChg chg="del">
          <ac:chgData name="雄康 大野" userId="289040ba27705a35" providerId="LiveId" clId="{79D7336E-6AC7-4D52-9A0E-E41A0F485719}" dt="2024-09-23T00:32:55.135" v="25" actId="478"/>
          <ac:graphicFrameMkLst>
            <pc:docMk/>
            <pc:sldMk cId="3201712340" sldId="258"/>
            <ac:graphicFrameMk id="6" creationId="{E322FEC5-0116-9D7F-3A0E-30A7FB2F5520}"/>
          </ac:graphicFrameMkLst>
        </pc:graphicFrameChg>
        <pc:graphicFrameChg chg="add mod">
          <ac:chgData name="雄康 大野" userId="289040ba27705a35" providerId="LiveId" clId="{79D7336E-6AC7-4D52-9A0E-E41A0F485719}" dt="2024-09-23T00:40:37.330" v="108" actId="1038"/>
          <ac:graphicFrameMkLst>
            <pc:docMk/>
            <pc:sldMk cId="3201712340" sldId="258"/>
            <ac:graphicFrameMk id="9" creationId="{DE8E6722-4C26-4884-3729-DC4FBD85908D}"/>
          </ac:graphicFrameMkLst>
        </pc:graphicFrameChg>
        <pc:graphicFrameChg chg="del">
          <ac:chgData name="雄康 大野" userId="289040ba27705a35" providerId="LiveId" clId="{79D7336E-6AC7-4D52-9A0E-E41A0F485719}" dt="2024-09-23T00:35:05.448" v="48" actId="478"/>
          <ac:graphicFrameMkLst>
            <pc:docMk/>
            <pc:sldMk cId="3201712340" sldId="258"/>
            <ac:graphicFrameMk id="10" creationId="{C19522A4-860A-EF83-752C-F0A35594A7B5}"/>
          </ac:graphicFrameMkLst>
        </pc:graphicFrameChg>
        <pc:graphicFrameChg chg="del">
          <ac:chgData name="雄康 大野" userId="289040ba27705a35" providerId="LiveId" clId="{79D7336E-6AC7-4D52-9A0E-E41A0F485719}" dt="2024-09-23T00:36:58.265" v="76" actId="478"/>
          <ac:graphicFrameMkLst>
            <pc:docMk/>
            <pc:sldMk cId="3201712340" sldId="258"/>
            <ac:graphicFrameMk id="11" creationId="{3C6299A0-9E3B-E66E-80AC-9F546E21461A}"/>
          </ac:graphicFrameMkLst>
        </pc:graphicFrameChg>
      </pc:sldChg>
    </pc:docChg>
  </pc:docChgLst>
  <pc:docChgLst>
    <pc:chgData name="雄康 大野" userId="289040ba27705a35" providerId="LiveId" clId="{633161D3-CA0C-4066-BCCC-61B791DABA9F}"/>
    <pc:docChg chg="custSel addSld delSld modSld sldOrd">
      <pc:chgData name="雄康 大野" userId="289040ba27705a35" providerId="LiveId" clId="{633161D3-CA0C-4066-BCCC-61B791DABA9F}" dt="2024-07-15T00:26:54.212" v="630" actId="1076"/>
      <pc:docMkLst>
        <pc:docMk/>
      </pc:docMkLst>
      <pc:sldChg chg="addSp delSp modSp del mod">
        <pc:chgData name="雄康 大野" userId="289040ba27705a35" providerId="LiveId" clId="{633161D3-CA0C-4066-BCCC-61B791DABA9F}" dt="2024-07-14T12:06:42.492" v="184" actId="47"/>
        <pc:sldMkLst>
          <pc:docMk/>
          <pc:sldMk cId="3398849434" sldId="256"/>
        </pc:sldMkLst>
        <pc:spChg chg="mod">
          <ac:chgData name="雄康 大野" userId="289040ba27705a35" providerId="LiveId" clId="{633161D3-CA0C-4066-BCCC-61B791DABA9F}" dt="2024-07-14T11:49:00.711" v="62" actId="20577"/>
          <ac:spMkLst>
            <pc:docMk/>
            <pc:sldMk cId="3398849434" sldId="256"/>
            <ac:spMk id="2" creationId="{9741318B-5FDD-00E8-764B-E684EBC99AF4}"/>
          </ac:spMkLst>
        </pc:spChg>
        <pc:spChg chg="mod">
          <ac:chgData name="雄康 大野" userId="289040ba27705a35" providerId="LiveId" clId="{633161D3-CA0C-4066-BCCC-61B791DABA9F}" dt="2024-07-14T11:48:38.780" v="48" actId="20577"/>
          <ac:spMkLst>
            <pc:docMk/>
            <pc:sldMk cId="3398849434" sldId="256"/>
            <ac:spMk id="3" creationId="{F8BBDCE6-5246-4B6C-23D3-E2B958AB9BF1}"/>
          </ac:spMkLst>
        </pc:spChg>
        <pc:graphicFrameChg chg="add del mod">
          <ac:chgData name="雄康 大野" userId="289040ba27705a35" providerId="LiveId" clId="{633161D3-CA0C-4066-BCCC-61B791DABA9F}" dt="2024-07-14T11:42:09.242" v="3" actId="478"/>
          <ac:graphicFrameMkLst>
            <pc:docMk/>
            <pc:sldMk cId="3398849434" sldId="256"/>
            <ac:graphicFrameMk id="4" creationId="{CF9E89EE-4634-C6BB-722C-A017269FB33C}"/>
          </ac:graphicFrameMkLst>
        </pc:graphicFrameChg>
        <pc:graphicFrameChg chg="mod modGraphic">
          <ac:chgData name="雄康 大野" userId="289040ba27705a35" providerId="LiveId" clId="{633161D3-CA0C-4066-BCCC-61B791DABA9F}" dt="2024-07-14T11:54:05.379" v="159" actId="20577"/>
          <ac:graphicFrameMkLst>
            <pc:docMk/>
            <pc:sldMk cId="3398849434" sldId="256"/>
            <ac:graphicFrameMk id="5" creationId="{EF955210-2507-6EC3-420A-01BE20A1E2F6}"/>
          </ac:graphicFrameMkLst>
        </pc:graphicFrameChg>
        <pc:graphicFrameChg chg="del">
          <ac:chgData name="雄康 大野" userId="289040ba27705a35" providerId="LiveId" clId="{633161D3-CA0C-4066-BCCC-61B791DABA9F}" dt="2024-07-14T11:40:31.620" v="0" actId="478"/>
          <ac:graphicFrameMkLst>
            <pc:docMk/>
            <pc:sldMk cId="3398849434" sldId="256"/>
            <ac:graphicFrameMk id="6" creationId="{F298689A-EB9D-DD0D-4A6A-2B403597FF4F}"/>
          </ac:graphicFrameMkLst>
        </pc:graphicFrameChg>
        <pc:graphicFrameChg chg="add mod">
          <ac:chgData name="雄康 大野" userId="289040ba27705a35" providerId="LiveId" clId="{633161D3-CA0C-4066-BCCC-61B791DABA9F}" dt="2024-07-14T11:44:59.057" v="7" actId="14100"/>
          <ac:graphicFrameMkLst>
            <pc:docMk/>
            <pc:sldMk cId="3398849434" sldId="256"/>
            <ac:graphicFrameMk id="7" creationId="{06D58F0F-2EC4-A451-52E3-6AFC545322DB}"/>
          </ac:graphicFrameMkLst>
        </pc:graphicFrameChg>
      </pc:sldChg>
      <pc:sldChg chg="addSp modSp add mod">
        <pc:chgData name="雄康 大野" userId="289040ba27705a35" providerId="LiveId" clId="{633161D3-CA0C-4066-BCCC-61B791DABA9F}" dt="2024-07-14T12:06:31.296" v="182" actId="122"/>
        <pc:sldMkLst>
          <pc:docMk/>
          <pc:sldMk cId="1480799046" sldId="257"/>
        </pc:sldMkLst>
        <pc:spChg chg="add mod">
          <ac:chgData name="雄康 大野" userId="289040ba27705a35" providerId="LiveId" clId="{633161D3-CA0C-4066-BCCC-61B791DABA9F}" dt="2024-07-14T12:06:31.296" v="182" actId="122"/>
          <ac:spMkLst>
            <pc:docMk/>
            <pc:sldMk cId="1480799046" sldId="257"/>
            <ac:spMk id="4" creationId="{ECC4E526-1495-889B-828A-1B060A87892B}"/>
          </ac:spMkLst>
        </pc:spChg>
      </pc:sldChg>
      <pc:sldChg chg="addSp delSp modSp add mod ord">
        <pc:chgData name="雄康 大野" userId="289040ba27705a35" providerId="LiveId" clId="{633161D3-CA0C-4066-BCCC-61B791DABA9F}" dt="2024-07-15T00:26:54.212" v="630" actId="1076"/>
        <pc:sldMkLst>
          <pc:docMk/>
          <pc:sldMk cId="3967253686" sldId="258"/>
        </pc:sldMkLst>
        <pc:spChg chg="mod">
          <ac:chgData name="雄康 大野" userId="289040ba27705a35" providerId="LiveId" clId="{633161D3-CA0C-4066-BCCC-61B791DABA9F}" dt="2024-07-15T00:26:45.045" v="629" actId="1038"/>
          <ac:spMkLst>
            <pc:docMk/>
            <pc:sldMk cId="3967253686" sldId="258"/>
            <ac:spMk id="2" creationId="{9741318B-5FDD-00E8-764B-E684EBC99AF4}"/>
          </ac:spMkLst>
        </pc:spChg>
        <pc:spChg chg="mod">
          <ac:chgData name="雄康 大野" userId="289040ba27705a35" providerId="LiveId" clId="{633161D3-CA0C-4066-BCCC-61B791DABA9F}" dt="2024-07-15T00:26:45.045" v="629" actId="1038"/>
          <ac:spMkLst>
            <pc:docMk/>
            <pc:sldMk cId="3967253686" sldId="258"/>
            <ac:spMk id="3" creationId="{F8BBDCE6-5246-4B6C-23D3-E2B958AB9BF1}"/>
          </ac:spMkLst>
        </pc:spChg>
        <pc:spChg chg="del mod">
          <ac:chgData name="雄康 大野" userId="289040ba27705a35" providerId="LiveId" clId="{633161D3-CA0C-4066-BCCC-61B791DABA9F}" dt="2024-07-15T00:02:04.858" v="306" actId="478"/>
          <ac:spMkLst>
            <pc:docMk/>
            <pc:sldMk cId="3967253686" sldId="258"/>
            <ac:spMk id="4" creationId="{ECC4E526-1495-889B-828A-1B060A87892B}"/>
          </ac:spMkLst>
        </pc:spChg>
        <pc:spChg chg="add mod">
          <ac:chgData name="雄康 大野" userId="289040ba27705a35" providerId="LiveId" clId="{633161D3-CA0C-4066-BCCC-61B791DABA9F}" dt="2024-07-15T00:26:54.212" v="630" actId="1076"/>
          <ac:spMkLst>
            <pc:docMk/>
            <pc:sldMk cId="3967253686" sldId="258"/>
            <ac:spMk id="7" creationId="{83B0FDE6-D68E-3FA2-96BF-8F0709E7A2A4}"/>
          </ac:spMkLst>
        </pc:spChg>
        <pc:graphicFrameChg chg="mod modGraphic">
          <ac:chgData name="雄康 大野" userId="289040ba27705a35" providerId="LiveId" clId="{633161D3-CA0C-4066-BCCC-61B791DABA9F}" dt="2024-07-15T00:26:45.045" v="629" actId="1038"/>
          <ac:graphicFrameMkLst>
            <pc:docMk/>
            <pc:sldMk cId="3967253686" sldId="258"/>
            <ac:graphicFrameMk id="5" creationId="{EF955210-2507-6EC3-420A-01BE20A1E2F6}"/>
          </ac:graphicFrameMkLst>
        </pc:graphicFrameChg>
        <pc:graphicFrameChg chg="add mod">
          <ac:chgData name="雄康 大野" userId="289040ba27705a35" providerId="LiveId" clId="{633161D3-CA0C-4066-BCCC-61B791DABA9F}" dt="2024-07-15T00:26:45.045" v="629" actId="1038"/>
          <ac:graphicFrameMkLst>
            <pc:docMk/>
            <pc:sldMk cId="3967253686" sldId="258"/>
            <ac:graphicFrameMk id="6" creationId="{D5FA6D27-5226-E74A-ABA7-4306F02CEE73}"/>
          </ac:graphicFrameMkLst>
        </pc:graphicFrameChg>
        <pc:graphicFrameChg chg="add del mod">
          <ac:chgData name="雄康 大野" userId="289040ba27705a35" providerId="LiveId" clId="{633161D3-CA0C-4066-BCCC-61B791DABA9F}" dt="2024-07-14T13:25:41.268" v="213" actId="478"/>
          <ac:graphicFrameMkLst>
            <pc:docMk/>
            <pc:sldMk cId="3967253686" sldId="258"/>
            <ac:graphicFrameMk id="6" creationId="{FDCB472E-E0F5-56D4-6C1A-CF7874D79082}"/>
          </ac:graphicFrameMkLst>
        </pc:graphicFrameChg>
        <pc:graphicFrameChg chg="del">
          <ac:chgData name="雄康 大野" userId="289040ba27705a35" providerId="LiveId" clId="{633161D3-CA0C-4066-BCCC-61B791DABA9F}" dt="2024-07-14T12:06:46.172" v="185" actId="478"/>
          <ac:graphicFrameMkLst>
            <pc:docMk/>
            <pc:sldMk cId="3967253686" sldId="258"/>
            <ac:graphicFrameMk id="7" creationId="{06D58F0F-2EC4-A451-52E3-6AFC545322DB}"/>
          </ac:graphicFrameMkLst>
        </pc:graphicFrameChg>
        <pc:graphicFrameChg chg="add del mod">
          <ac:chgData name="雄康 大野" userId="289040ba27705a35" providerId="LiveId" clId="{633161D3-CA0C-4066-BCCC-61B791DABA9F}" dt="2024-07-14T23:58:08.931" v="221" actId="478"/>
          <ac:graphicFrameMkLst>
            <pc:docMk/>
            <pc:sldMk cId="3967253686" sldId="258"/>
            <ac:graphicFrameMk id="8" creationId="{C49C5700-1832-8E94-D74C-7C12DCC79F03}"/>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4108BCB-97D3-407A-8C52-02B53E360D6D}" type="datetimeFigureOut">
              <a:rPr kumimoji="1" lang="ja-JP" altLang="en-US" smtClean="0"/>
              <a:t>2024/11/12</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F8D901-7FD4-4A86-A324-C1DAF880C707}" type="slidenum">
              <a:rPr kumimoji="1" lang="ja-JP" altLang="en-US" smtClean="0"/>
              <a:t>‹#›</a:t>
            </a:fld>
            <a:endParaRPr kumimoji="1" lang="ja-JP" altLang="en-US"/>
          </a:p>
        </p:txBody>
      </p:sp>
    </p:spTree>
    <p:extLst>
      <p:ext uri="{BB962C8B-B14F-4D97-AF65-F5344CB8AC3E}">
        <p14:creationId xmlns:p14="http://schemas.microsoft.com/office/powerpoint/2010/main" val="19841690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a:lnSpc>
                <a:spcPct val="200000"/>
              </a:lnSpc>
            </a:pPr>
            <a:r>
              <a:rPr lang="en-US" altLang="ja-JP" sz="1800" b="1" kern="100" dirty="0">
                <a:effectLst/>
                <a:latin typeface="Times New Roman" panose="02020603050405020304" pitchFamily="18" charset="0"/>
                <a:ea typeface="游明朝" panose="02020400000000000000" pitchFamily="18" charset="-128"/>
                <a:cs typeface="Times New Roman" panose="02020603050405020304" pitchFamily="18" charset="0"/>
              </a:rPr>
              <a:t>S4 Fig. Prehospital and hospital LOS among injured patients: standard vehicle group versus K-car vehicle group.</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nSpc>
                <a:spcPct val="200000"/>
              </a:lnSpc>
            </a:pPr>
            <a:r>
              <a:rPr lang="en-US" altLang="ja-JP" sz="1800" kern="100" dirty="0">
                <a:effectLst/>
                <a:latin typeface="Times New Roman" panose="02020603050405020304" pitchFamily="18" charset="0"/>
                <a:ea typeface="游明朝" panose="02020400000000000000" pitchFamily="18" charset="-128"/>
                <a:cs typeface="Times New Roman" panose="02020603050405020304" pitchFamily="18" charset="0"/>
              </a:rPr>
              <a:t>(A, B) Prehospital LOS in the full (A) and PS-matched (B) cohort. (C, D) Hospital LOS in the full (C) and PS-matched (D) cohort. Prehospital LOS is defined as time from the emergency call to ED arrival. Hospital LOS is defined as time from hospital admission to hospital discharge or transfer. representing the data distribution (circles), mean (horizontal bar), and interquartile range (vertical bar), respectively. The p-values are derived from the Mann–Whitney U-test. </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nSpc>
                <a:spcPct val="200000"/>
              </a:lnSpc>
            </a:pPr>
            <a:r>
              <a:rPr lang="en-US" altLang="ja-JP" sz="1800" kern="100">
                <a:effectLst/>
                <a:latin typeface="Times New Roman" panose="02020603050405020304" pitchFamily="18" charset="0"/>
                <a:ea typeface="游明朝" panose="02020400000000000000" pitchFamily="18" charset="-128"/>
                <a:cs typeface="Times New Roman" panose="02020603050405020304" pitchFamily="18" charset="0"/>
              </a:rPr>
              <a:t>LOS, length of stay; PS, propensity score; ED, emergency department.</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4" name="スライド番号プレースホルダー 3"/>
          <p:cNvSpPr>
            <a:spLocks noGrp="1"/>
          </p:cNvSpPr>
          <p:nvPr>
            <p:ph type="sldNum" sz="quarter" idx="5"/>
          </p:nvPr>
        </p:nvSpPr>
        <p:spPr/>
        <p:txBody>
          <a:bodyPr/>
          <a:lstStyle/>
          <a:p>
            <a:fld id="{92F8D901-7FD4-4A86-A324-C1DAF880C707}" type="slidenum">
              <a:rPr kumimoji="1" lang="ja-JP" altLang="en-US" smtClean="0"/>
              <a:t>1</a:t>
            </a:fld>
            <a:endParaRPr kumimoji="1" lang="ja-JP" altLang="en-US"/>
          </a:p>
        </p:txBody>
      </p:sp>
    </p:spTree>
    <p:extLst>
      <p:ext uri="{BB962C8B-B14F-4D97-AF65-F5344CB8AC3E}">
        <p14:creationId xmlns:p14="http://schemas.microsoft.com/office/powerpoint/2010/main" val="22577786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AA82203-E9C2-79B5-F2A6-296D4F8D83F3}"/>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F5351052-E78F-830F-0515-221DE4DD005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300CFA22-6C47-C7E6-FDDB-6658205A1820}"/>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8EA359DA-E97E-D4D9-2A24-16FBCA4547C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E87C223-A5ED-255E-C8EB-D17F8BB2102C}"/>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27691436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B6375F9-2687-08FC-6C04-6A3A97B7E4DD}"/>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E7FC6154-758F-E60E-D41E-A09803572D4C}"/>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C3DA32E-D00F-BDC6-A926-EE2ECCE2BCFC}"/>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E9B97F92-EC27-4530-F6E0-BAA7043A538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739D7C1-FEBB-14CE-B38A-5C60799F5622}"/>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35073247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B2BD99C6-D52B-7B29-CFB1-EF4BAEFC2035}"/>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6B407232-A546-A202-0BB7-6DAB37C75278}"/>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226CB81-CEB8-422F-A65B-D254DDC0802F}"/>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CEDA519F-C0CA-D9F0-50EC-FF1A35B4CF1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CE8F942-BB70-E43E-8E4F-5AEBF5245DAD}"/>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2662145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3F3B9D8-26FF-F199-2642-2B010356C8A1}"/>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9D4F9EE-170C-58E0-DA2B-F2B940CD6194}"/>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559CD7D-10FA-060B-19C2-40193BDBE089}"/>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45562D33-1DFB-922D-01B3-D53AD68F35F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1C7A3B5-60A7-3E1E-4ED9-2BE69692093A}"/>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18870278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6CA2DD0-3DFA-5A12-4157-8D7934012443}"/>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DFB4CBA-3A76-8B9E-1B5D-B52424583A6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F5A87EE3-CA90-1A09-9905-D26E6D9526D2}"/>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A9DB90AA-AB18-532A-DE41-C6B8A551A48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9F566C1-DEEE-BE3B-DEA1-46014895B934}"/>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33908224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470F06C-77DA-03A9-F1A9-5A15F8CDFF2E}"/>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29319DE7-526C-9A77-E594-81ABB5BBA350}"/>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0573E100-6E3C-8281-8A48-A03458A32963}"/>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5685C352-6024-A6D3-D363-542AFD7A8147}"/>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6" name="フッター プレースホルダー 5">
            <a:extLst>
              <a:ext uri="{FF2B5EF4-FFF2-40B4-BE49-F238E27FC236}">
                <a16:creationId xmlns:a16="http://schemas.microsoft.com/office/drawing/2014/main" id="{2C8DE9B7-8BDB-199D-9A3F-D8E565C89C4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2D9A3B0-F8E3-9025-A444-3ED0C56AA1CB}"/>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15478830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0E9C443-FF97-123E-BB81-4A2DF1D4CA68}"/>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8549A72-62E7-674D-2FEE-6455D0A1572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E1C33D50-0495-2D67-B41F-EBE9521930A5}"/>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5BBED24D-98E3-A923-E5E4-9019A22ED95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792D7C55-A070-D121-C69B-13B6C064F4B9}"/>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6504A817-EE13-9FBE-97CF-130C7884B5B1}"/>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8" name="フッター プレースホルダー 7">
            <a:extLst>
              <a:ext uri="{FF2B5EF4-FFF2-40B4-BE49-F238E27FC236}">
                <a16:creationId xmlns:a16="http://schemas.microsoft.com/office/drawing/2014/main" id="{A77C5837-30F3-864E-1593-026B7A0BBE7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F60BCCA-94C0-29A3-6B35-9F7A3551C503}"/>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28148031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5DF133C-F6E4-F800-B025-66D4FC11F0D6}"/>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FC21C2C6-3123-F40C-B1A3-E17552A50AC9}"/>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4" name="フッター プレースホルダー 3">
            <a:extLst>
              <a:ext uri="{FF2B5EF4-FFF2-40B4-BE49-F238E27FC236}">
                <a16:creationId xmlns:a16="http://schemas.microsoft.com/office/drawing/2014/main" id="{8512214A-E282-DA75-9055-CBD2C0A06635}"/>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DD7FCA06-B6A2-B1DD-E490-01E76D6A1D6D}"/>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9209186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C7B2ED59-B1B5-E131-E608-7AEAD01904EB}"/>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3" name="フッター プレースホルダー 2">
            <a:extLst>
              <a:ext uri="{FF2B5EF4-FFF2-40B4-BE49-F238E27FC236}">
                <a16:creationId xmlns:a16="http://schemas.microsoft.com/office/drawing/2014/main" id="{E9CE295D-43AE-22D1-873B-502C71FD68B0}"/>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95D87208-C3A1-C619-CC74-287DAC8B8DBB}"/>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2177216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D94A3EF-1C25-9A1C-FEBA-990B7DD3943D}"/>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D34A2FA-1643-010A-91B4-7FFF5B419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6BAA302C-2154-F0A5-A263-B09FD34DCF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9061A52B-F675-C81C-D816-A76FFF6757FA}"/>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6" name="フッター プレースホルダー 5">
            <a:extLst>
              <a:ext uri="{FF2B5EF4-FFF2-40B4-BE49-F238E27FC236}">
                <a16:creationId xmlns:a16="http://schemas.microsoft.com/office/drawing/2014/main" id="{70449EDD-70E5-84B3-8D7C-0F141DC89E7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62C0596-AFAA-42FB-0F09-2FAE678DB3F2}"/>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12906393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71E5A36-BBD7-B36D-F0FA-DF36713C72B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66BFF112-7257-A6C5-280C-541C76ED62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A435CB79-5A1D-779E-3A47-7875D520D58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BCB7FC8E-FB10-49A8-5743-F0F1D3B3C7F2}"/>
              </a:ext>
            </a:extLst>
          </p:cNvPr>
          <p:cNvSpPr>
            <a:spLocks noGrp="1"/>
          </p:cNvSpPr>
          <p:nvPr>
            <p:ph type="dt" sz="half" idx="10"/>
          </p:nvPr>
        </p:nvSpPr>
        <p:spPr/>
        <p:txBody>
          <a:bodyPr/>
          <a:lstStyle/>
          <a:p>
            <a:fld id="{9E02A334-A298-40B8-BBF4-1B3B99310889}" type="datetimeFigureOut">
              <a:rPr kumimoji="1" lang="ja-JP" altLang="en-US" smtClean="0"/>
              <a:t>2024/11/12</a:t>
            </a:fld>
            <a:endParaRPr kumimoji="1" lang="ja-JP" altLang="en-US"/>
          </a:p>
        </p:txBody>
      </p:sp>
      <p:sp>
        <p:nvSpPr>
          <p:cNvPr id="6" name="フッター プレースホルダー 5">
            <a:extLst>
              <a:ext uri="{FF2B5EF4-FFF2-40B4-BE49-F238E27FC236}">
                <a16:creationId xmlns:a16="http://schemas.microsoft.com/office/drawing/2014/main" id="{65B8CA35-7D46-58CD-7D1A-4839B0A863C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6032F81-16FE-4B35-EF2B-807EF2A37C5E}"/>
              </a:ext>
            </a:extLst>
          </p:cNvPr>
          <p:cNvSpPr>
            <a:spLocks noGrp="1"/>
          </p:cNvSpPr>
          <p:nvPr>
            <p:ph type="sldNum" sz="quarter" idx="12"/>
          </p:nvPr>
        </p:nvSpPr>
        <p:spPr/>
        <p:txBody>
          <a:body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38010304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C5665C6-15FC-5D41-C2EB-F897774713A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DAECAF7-2FA8-77B2-F5F8-573E043134C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5A0A6DF-898D-9523-4E12-B2226A6D44C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E02A334-A298-40B8-BBF4-1B3B99310889}" type="datetimeFigureOut">
              <a:rPr kumimoji="1" lang="ja-JP" altLang="en-US" smtClean="0"/>
              <a:t>2024/11/12</a:t>
            </a:fld>
            <a:endParaRPr kumimoji="1" lang="ja-JP" altLang="en-US"/>
          </a:p>
        </p:txBody>
      </p:sp>
      <p:sp>
        <p:nvSpPr>
          <p:cNvPr id="5" name="フッター プレースホルダー 4">
            <a:extLst>
              <a:ext uri="{FF2B5EF4-FFF2-40B4-BE49-F238E27FC236}">
                <a16:creationId xmlns:a16="http://schemas.microsoft.com/office/drawing/2014/main" id="{E7282453-367C-9F1F-9573-92DED5B49EC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B50CC7D7-B983-2063-A01A-B84E13A3714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B83DE4-BAF0-43A3-B43C-94A38B6C027A}" type="slidenum">
              <a:rPr kumimoji="1" lang="ja-JP" altLang="en-US" smtClean="0"/>
              <a:t>‹#›</a:t>
            </a:fld>
            <a:endParaRPr kumimoji="1" lang="ja-JP" altLang="en-US"/>
          </a:p>
        </p:txBody>
      </p:sp>
    </p:spTree>
    <p:extLst>
      <p:ext uri="{BB962C8B-B14F-4D97-AF65-F5344CB8AC3E}">
        <p14:creationId xmlns:p14="http://schemas.microsoft.com/office/powerpoint/2010/main" val="16030105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6">
            <a:extLst>
              <a:ext uri="{FF2B5EF4-FFF2-40B4-BE49-F238E27FC236}">
                <a16:creationId xmlns:a16="http://schemas.microsoft.com/office/drawing/2014/main" id="{13D4A0DC-A832-A0D0-05E9-DA55C54B266E}"/>
              </a:ext>
            </a:extLst>
          </p:cNvPr>
          <p:cNvSpPr txBox="1"/>
          <p:nvPr/>
        </p:nvSpPr>
        <p:spPr>
          <a:xfrm>
            <a:off x="3513996" y="1610296"/>
            <a:ext cx="3096953" cy="523220"/>
          </a:xfrm>
          <a:prstGeom prst="rect">
            <a:avLst/>
          </a:prstGeom>
          <a:noFill/>
        </p:spPr>
        <p:txBody>
          <a:bodyPr wrap="square" rtlCol="0">
            <a:spAutoFit/>
          </a:bodyPr>
          <a:lstStyle/>
          <a:p>
            <a:r>
              <a:rPr kumimoji="1" lang="ja-JP" altLang="en-US" sz="1400" dirty="0">
                <a:solidFill>
                  <a:srgbClr val="3B3BFF"/>
                </a:solidFill>
                <a:latin typeface="Arial" panose="020B0604020202020204" pitchFamily="34" charset="0"/>
                <a:cs typeface="Arial" panose="020B0604020202020204" pitchFamily="34" charset="0"/>
              </a:rPr>
              <a:t>●</a:t>
            </a:r>
            <a:r>
              <a:rPr kumimoji="1" lang="en-US" altLang="ja-JP" sz="1400" dirty="0">
                <a:latin typeface="Arial" panose="020B0604020202020204" pitchFamily="34" charset="0"/>
                <a:cs typeface="Arial" panose="020B0604020202020204" pitchFamily="34" charset="0"/>
              </a:rPr>
              <a:t>Standard vehicle (n = 2947)</a:t>
            </a:r>
            <a:r>
              <a:rPr kumimoji="1" lang="en-US" altLang="ja-JP" sz="1400" dirty="0">
                <a:solidFill>
                  <a:srgbClr val="8080FF"/>
                </a:solidFill>
                <a:latin typeface="Arial" panose="020B0604020202020204" pitchFamily="34" charset="0"/>
                <a:cs typeface="Arial" panose="020B0604020202020204" pitchFamily="34" charset="0"/>
              </a:rPr>
              <a:t>	</a:t>
            </a:r>
          </a:p>
          <a:p>
            <a:r>
              <a:rPr lang="ja-JP" altLang="en-US" sz="1400" dirty="0">
                <a:solidFill>
                  <a:srgbClr val="FF0000"/>
                </a:solidFill>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K-car vehicle (n = 2384)</a:t>
            </a:r>
            <a:endParaRPr kumimoji="1" lang="ja-JP" altLang="en-US" sz="14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A5912FA1-86E7-047A-2857-EE8852E9B190}"/>
              </a:ext>
            </a:extLst>
          </p:cNvPr>
          <p:cNvSpPr txBox="1"/>
          <p:nvPr/>
        </p:nvSpPr>
        <p:spPr>
          <a:xfrm>
            <a:off x="9392628" y="1429777"/>
            <a:ext cx="2932361" cy="523220"/>
          </a:xfrm>
          <a:prstGeom prst="rect">
            <a:avLst/>
          </a:prstGeom>
          <a:noFill/>
        </p:spPr>
        <p:txBody>
          <a:bodyPr wrap="square" rtlCol="0">
            <a:spAutoFit/>
          </a:bodyPr>
          <a:lstStyle/>
          <a:p>
            <a:r>
              <a:rPr kumimoji="1" lang="ja-JP" altLang="en-US" sz="1400" dirty="0">
                <a:solidFill>
                  <a:srgbClr val="3B3BFF"/>
                </a:solidFill>
                <a:latin typeface="Arial" panose="020B0604020202020204" pitchFamily="34" charset="0"/>
                <a:cs typeface="Arial" panose="020B0604020202020204" pitchFamily="34" charset="0"/>
              </a:rPr>
              <a:t>●</a:t>
            </a:r>
            <a:r>
              <a:rPr kumimoji="1" lang="en-US" altLang="ja-JP" sz="1400" dirty="0">
                <a:latin typeface="Arial" panose="020B0604020202020204" pitchFamily="34" charset="0"/>
                <a:cs typeface="Arial" panose="020B0604020202020204" pitchFamily="34" charset="0"/>
              </a:rPr>
              <a:t>Standard vehicle (n = 1947)</a:t>
            </a:r>
            <a:r>
              <a:rPr kumimoji="1" lang="en-US" altLang="ja-JP" sz="1400" dirty="0">
                <a:solidFill>
                  <a:srgbClr val="8080FF"/>
                </a:solidFill>
                <a:latin typeface="Arial" panose="020B0604020202020204" pitchFamily="34" charset="0"/>
                <a:cs typeface="Arial" panose="020B0604020202020204" pitchFamily="34" charset="0"/>
              </a:rPr>
              <a:t>	</a:t>
            </a:r>
          </a:p>
          <a:p>
            <a:r>
              <a:rPr lang="ja-JP" altLang="en-US" sz="1400" dirty="0">
                <a:solidFill>
                  <a:srgbClr val="FF0000"/>
                </a:solidFill>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K-car vehicle (n = 1947)</a:t>
            </a:r>
            <a:endParaRPr kumimoji="1" lang="ja-JP" altLang="en-US" sz="14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10CAAB8C-00E5-370A-C099-2BCFAAB7B89F}"/>
              </a:ext>
            </a:extLst>
          </p:cNvPr>
          <p:cNvSpPr txBox="1"/>
          <p:nvPr/>
        </p:nvSpPr>
        <p:spPr>
          <a:xfrm>
            <a:off x="3443154" y="4442049"/>
            <a:ext cx="3096953" cy="523220"/>
          </a:xfrm>
          <a:prstGeom prst="rect">
            <a:avLst/>
          </a:prstGeom>
          <a:noFill/>
        </p:spPr>
        <p:txBody>
          <a:bodyPr wrap="square" rtlCol="0">
            <a:spAutoFit/>
          </a:bodyPr>
          <a:lstStyle/>
          <a:p>
            <a:r>
              <a:rPr kumimoji="1" lang="ja-JP" altLang="en-US" sz="1400" dirty="0">
                <a:solidFill>
                  <a:srgbClr val="3B3BFF"/>
                </a:solidFill>
                <a:latin typeface="Arial" panose="020B0604020202020204" pitchFamily="34" charset="0"/>
                <a:cs typeface="Arial" panose="020B0604020202020204" pitchFamily="34" charset="0"/>
              </a:rPr>
              <a:t>●</a:t>
            </a:r>
            <a:r>
              <a:rPr kumimoji="1" lang="en-US" altLang="ja-JP" sz="1400" dirty="0">
                <a:latin typeface="Arial" panose="020B0604020202020204" pitchFamily="34" charset="0"/>
                <a:cs typeface="Arial" panose="020B0604020202020204" pitchFamily="34" charset="0"/>
              </a:rPr>
              <a:t>Standard vehicle (n = 714)</a:t>
            </a:r>
            <a:r>
              <a:rPr kumimoji="1" lang="en-US" altLang="ja-JP" sz="1400" dirty="0">
                <a:solidFill>
                  <a:srgbClr val="8080FF"/>
                </a:solidFill>
                <a:latin typeface="Arial" panose="020B0604020202020204" pitchFamily="34" charset="0"/>
                <a:cs typeface="Arial" panose="020B0604020202020204" pitchFamily="34" charset="0"/>
              </a:rPr>
              <a:t>	</a:t>
            </a:r>
          </a:p>
          <a:p>
            <a:r>
              <a:rPr lang="ja-JP" altLang="en-US" sz="1400" dirty="0">
                <a:solidFill>
                  <a:srgbClr val="FF0000"/>
                </a:solidFill>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K-car vehicle (n = 742)</a:t>
            </a:r>
            <a:endParaRPr kumimoji="1" lang="ja-JP" altLang="en-US" sz="14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6096C029-EE92-CBD9-F0CC-7586C46FCAF7}"/>
              </a:ext>
            </a:extLst>
          </p:cNvPr>
          <p:cNvSpPr txBox="1"/>
          <p:nvPr/>
        </p:nvSpPr>
        <p:spPr>
          <a:xfrm>
            <a:off x="9428751" y="4442049"/>
            <a:ext cx="3096953" cy="523220"/>
          </a:xfrm>
          <a:prstGeom prst="rect">
            <a:avLst/>
          </a:prstGeom>
          <a:noFill/>
        </p:spPr>
        <p:txBody>
          <a:bodyPr wrap="square" rtlCol="0">
            <a:spAutoFit/>
          </a:bodyPr>
          <a:lstStyle/>
          <a:p>
            <a:r>
              <a:rPr kumimoji="1" lang="ja-JP" altLang="en-US" sz="1400" dirty="0">
                <a:solidFill>
                  <a:srgbClr val="3B3BFF"/>
                </a:solidFill>
                <a:latin typeface="Arial" panose="020B0604020202020204" pitchFamily="34" charset="0"/>
                <a:cs typeface="Arial" panose="020B0604020202020204" pitchFamily="34" charset="0"/>
              </a:rPr>
              <a:t>●</a:t>
            </a:r>
            <a:r>
              <a:rPr kumimoji="1" lang="en-US" altLang="ja-JP" sz="1400" dirty="0">
                <a:latin typeface="Arial" panose="020B0604020202020204" pitchFamily="34" charset="0"/>
                <a:cs typeface="Arial" panose="020B0604020202020204" pitchFamily="34" charset="0"/>
              </a:rPr>
              <a:t>Standard vehicle (n = 511)</a:t>
            </a:r>
            <a:r>
              <a:rPr kumimoji="1" lang="en-US" altLang="ja-JP" sz="1400" dirty="0">
                <a:solidFill>
                  <a:srgbClr val="8080FF"/>
                </a:solidFill>
                <a:latin typeface="Arial" panose="020B0604020202020204" pitchFamily="34" charset="0"/>
                <a:cs typeface="Arial" panose="020B0604020202020204" pitchFamily="34" charset="0"/>
              </a:rPr>
              <a:t>	</a:t>
            </a:r>
          </a:p>
          <a:p>
            <a:r>
              <a:rPr lang="ja-JP" altLang="en-US" sz="1400" dirty="0">
                <a:solidFill>
                  <a:srgbClr val="FF0000"/>
                </a:solidFill>
                <a:latin typeface="Arial" panose="020B0604020202020204" pitchFamily="34" charset="0"/>
                <a:cs typeface="Arial" panose="020B0604020202020204" pitchFamily="34" charset="0"/>
              </a:rPr>
              <a:t>●</a:t>
            </a:r>
            <a:r>
              <a:rPr lang="en-US" altLang="ja-JP" sz="1400" dirty="0">
                <a:latin typeface="Arial" panose="020B0604020202020204" pitchFamily="34" charset="0"/>
                <a:cs typeface="Arial" panose="020B0604020202020204" pitchFamily="34" charset="0"/>
              </a:rPr>
              <a:t>K-car vehicle (n = 569)</a:t>
            </a:r>
            <a:endParaRPr kumimoji="1" lang="ja-JP" altLang="en-US" sz="14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33E01427-2796-553F-A879-4012030A3D9C}"/>
              </a:ext>
            </a:extLst>
          </p:cNvPr>
          <p:cNvSpPr txBox="1"/>
          <p:nvPr/>
        </p:nvSpPr>
        <p:spPr>
          <a:xfrm>
            <a:off x="-4703" y="20104"/>
            <a:ext cx="466531" cy="461665"/>
          </a:xfrm>
          <a:prstGeom prst="rect">
            <a:avLst/>
          </a:prstGeom>
          <a:noFill/>
        </p:spPr>
        <p:txBody>
          <a:bodyPr wrap="square" rtlCol="0">
            <a:spAutoFit/>
          </a:bodyPr>
          <a:lstStyle/>
          <a:p>
            <a:r>
              <a:rPr lang="en-US" altLang="ja-JP" sz="2400" b="1" dirty="0">
                <a:latin typeface="Arial" panose="020B0604020202020204" pitchFamily="34" charset="0"/>
                <a:cs typeface="Arial" panose="020B0604020202020204" pitchFamily="34" charset="0"/>
              </a:rPr>
              <a:t>A</a:t>
            </a:r>
            <a:endParaRPr kumimoji="1" lang="ja-JP" altLang="en-US" sz="2400" b="1"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49A8C392-2B48-B25C-4286-B1D74625E380}"/>
              </a:ext>
            </a:extLst>
          </p:cNvPr>
          <p:cNvSpPr txBox="1"/>
          <p:nvPr/>
        </p:nvSpPr>
        <p:spPr>
          <a:xfrm>
            <a:off x="6123962" y="0"/>
            <a:ext cx="466531" cy="461665"/>
          </a:xfrm>
          <a:prstGeom prst="rect">
            <a:avLst/>
          </a:prstGeom>
          <a:noFill/>
        </p:spPr>
        <p:txBody>
          <a:bodyPr wrap="square" rtlCol="0">
            <a:spAutoFit/>
          </a:bodyPr>
          <a:lstStyle/>
          <a:p>
            <a:r>
              <a:rPr lang="en-US" altLang="ja-JP" sz="2400" b="1" dirty="0">
                <a:latin typeface="Arial" panose="020B0604020202020204" pitchFamily="34" charset="0"/>
                <a:cs typeface="Arial" panose="020B0604020202020204" pitchFamily="34" charset="0"/>
              </a:rPr>
              <a:t>B</a:t>
            </a:r>
            <a:endParaRPr kumimoji="1" lang="ja-JP" altLang="en-US" sz="2400" b="1"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DF0871CA-432A-6794-0B7A-706DC4CBED91}"/>
              </a:ext>
            </a:extLst>
          </p:cNvPr>
          <p:cNvSpPr txBox="1"/>
          <p:nvPr/>
        </p:nvSpPr>
        <p:spPr>
          <a:xfrm>
            <a:off x="36080" y="3431811"/>
            <a:ext cx="466531" cy="461665"/>
          </a:xfrm>
          <a:prstGeom prst="rect">
            <a:avLst/>
          </a:prstGeom>
          <a:noFill/>
        </p:spPr>
        <p:txBody>
          <a:bodyPr wrap="square" rtlCol="0">
            <a:spAutoFit/>
          </a:bodyPr>
          <a:lstStyle/>
          <a:p>
            <a:r>
              <a:rPr lang="en-US" altLang="ja-JP" sz="2400" b="1" dirty="0">
                <a:latin typeface="Arial" panose="020B0604020202020204" pitchFamily="34" charset="0"/>
                <a:cs typeface="Arial" panose="020B0604020202020204" pitchFamily="34" charset="0"/>
              </a:rPr>
              <a:t>C</a:t>
            </a:r>
            <a:endParaRPr kumimoji="1" lang="ja-JP" altLang="en-US" sz="2400" b="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29060193-F586-D5CC-A900-289F9B146903}"/>
              </a:ext>
            </a:extLst>
          </p:cNvPr>
          <p:cNvSpPr txBox="1"/>
          <p:nvPr/>
        </p:nvSpPr>
        <p:spPr>
          <a:xfrm>
            <a:off x="6124280" y="3452648"/>
            <a:ext cx="466531" cy="461665"/>
          </a:xfrm>
          <a:prstGeom prst="rect">
            <a:avLst/>
          </a:prstGeom>
          <a:noFill/>
        </p:spPr>
        <p:txBody>
          <a:bodyPr wrap="square" rtlCol="0">
            <a:spAutoFit/>
          </a:bodyPr>
          <a:lstStyle/>
          <a:p>
            <a:r>
              <a:rPr lang="en-US" altLang="ja-JP" sz="2400" b="1" dirty="0">
                <a:latin typeface="Arial" panose="020B0604020202020204" pitchFamily="34" charset="0"/>
                <a:cs typeface="Arial" panose="020B0604020202020204" pitchFamily="34" charset="0"/>
              </a:rPr>
              <a:t>D</a:t>
            </a:r>
            <a:endParaRPr kumimoji="1" lang="ja-JP" altLang="en-US" sz="2400" b="1"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105E6E26-1515-F49B-E75C-D74F0889C90F}"/>
              </a:ext>
            </a:extLst>
          </p:cNvPr>
          <p:cNvSpPr txBox="1"/>
          <p:nvPr/>
        </p:nvSpPr>
        <p:spPr>
          <a:xfrm>
            <a:off x="-56562" y="32879"/>
            <a:ext cx="6095999" cy="338554"/>
          </a:xfrm>
          <a:prstGeom prst="rect">
            <a:avLst/>
          </a:prstGeom>
          <a:noFill/>
        </p:spPr>
        <p:txBody>
          <a:bodyPr wrap="square" rtlCol="0">
            <a:spAutoFit/>
          </a:bodyPr>
          <a:lstStyle/>
          <a:p>
            <a:pPr algn="ctr"/>
            <a:r>
              <a:rPr lang="en-US" altLang="ja-JP" sz="1600" b="1" u="sng" dirty="0">
                <a:latin typeface="Arial" panose="020B0604020202020204" pitchFamily="34" charset="0"/>
                <a:cs typeface="Arial" panose="020B0604020202020204" pitchFamily="34" charset="0"/>
              </a:rPr>
              <a:t>Full cohort</a:t>
            </a:r>
            <a:endParaRPr kumimoji="1" lang="ja-JP" altLang="en-US" sz="1600" b="1" u="sng"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AF6F46B1-B30F-6B42-4728-3C8BB4882198}"/>
              </a:ext>
            </a:extLst>
          </p:cNvPr>
          <p:cNvSpPr txBox="1"/>
          <p:nvPr/>
        </p:nvSpPr>
        <p:spPr>
          <a:xfrm>
            <a:off x="6095999" y="21264"/>
            <a:ext cx="6096000" cy="338554"/>
          </a:xfrm>
          <a:prstGeom prst="rect">
            <a:avLst/>
          </a:prstGeom>
          <a:noFill/>
        </p:spPr>
        <p:txBody>
          <a:bodyPr wrap="square" rtlCol="0">
            <a:spAutoFit/>
          </a:bodyPr>
          <a:lstStyle/>
          <a:p>
            <a:pPr algn="ctr"/>
            <a:r>
              <a:rPr lang="en-US" altLang="ja-JP" sz="1600" b="1" u="sng" dirty="0">
                <a:latin typeface="Arial" panose="020B0604020202020204" pitchFamily="34" charset="0"/>
                <a:cs typeface="Arial" panose="020B0604020202020204" pitchFamily="34" charset="0"/>
              </a:rPr>
              <a:t>PS-matched cohort</a:t>
            </a:r>
            <a:endParaRPr kumimoji="1" lang="ja-JP" altLang="en-US" sz="1600" b="1" u="sng"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D00D9B2B-C895-6791-ACA1-CDBB5BB5F319}"/>
              </a:ext>
            </a:extLst>
          </p:cNvPr>
          <p:cNvSpPr txBox="1"/>
          <p:nvPr/>
        </p:nvSpPr>
        <p:spPr>
          <a:xfrm>
            <a:off x="2015287" y="432258"/>
            <a:ext cx="1133919" cy="276998"/>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P&lt; 0.001</a:t>
            </a:r>
            <a:endParaRPr kumimoji="1" lang="ja-JP" altLang="en-US" sz="1200"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127459E3-D2DC-370C-5846-7C2E665AD9B7}"/>
              </a:ext>
            </a:extLst>
          </p:cNvPr>
          <p:cNvSpPr txBox="1"/>
          <p:nvPr/>
        </p:nvSpPr>
        <p:spPr>
          <a:xfrm>
            <a:off x="8129444" y="538739"/>
            <a:ext cx="1130740" cy="276998"/>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P=0.529</a:t>
            </a:r>
            <a:endParaRPr kumimoji="1" lang="ja-JP" altLang="en-US" sz="1200"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56E62565-C254-3F26-4CFB-807024A66FF7}"/>
              </a:ext>
            </a:extLst>
          </p:cNvPr>
          <p:cNvSpPr txBox="1"/>
          <p:nvPr/>
        </p:nvSpPr>
        <p:spPr>
          <a:xfrm>
            <a:off x="2018466" y="3879296"/>
            <a:ext cx="1130740" cy="276998"/>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P=0.164</a:t>
            </a:r>
            <a:endParaRPr kumimoji="1" lang="ja-JP" altLang="en-US" sz="12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D56D9057-8E99-A319-F1D1-893602AE7E3E}"/>
              </a:ext>
            </a:extLst>
          </p:cNvPr>
          <p:cNvSpPr txBox="1"/>
          <p:nvPr/>
        </p:nvSpPr>
        <p:spPr>
          <a:xfrm>
            <a:off x="8129444" y="3775814"/>
            <a:ext cx="1130740" cy="276998"/>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P=0.110</a:t>
            </a:r>
            <a:endParaRPr kumimoji="1" lang="ja-JP" altLang="en-US" sz="1200" dirty="0">
              <a:latin typeface="Arial" panose="020B0604020202020204" pitchFamily="34" charset="0"/>
              <a:cs typeface="Arial" panose="020B0604020202020204" pitchFamily="34" charset="0"/>
            </a:endParaRPr>
          </a:p>
        </p:txBody>
      </p:sp>
      <p:graphicFrame>
        <p:nvGraphicFramePr>
          <p:cNvPr id="2" name="オブジェクト 1">
            <a:extLst>
              <a:ext uri="{FF2B5EF4-FFF2-40B4-BE49-F238E27FC236}">
                <a16:creationId xmlns:a16="http://schemas.microsoft.com/office/drawing/2014/main" id="{D44CEAF4-56E1-466A-FC84-E21F57864C9D}"/>
              </a:ext>
            </a:extLst>
          </p:cNvPr>
          <p:cNvGraphicFramePr>
            <a:graphicFrameLocks noChangeAspect="1"/>
          </p:cNvGraphicFramePr>
          <p:nvPr>
            <p:extLst>
              <p:ext uri="{D42A27DB-BD31-4B8C-83A1-F6EECF244321}">
                <p14:modId xmlns:p14="http://schemas.microsoft.com/office/powerpoint/2010/main" val="1828436352"/>
              </p:ext>
            </p:extLst>
          </p:nvPr>
        </p:nvGraphicFramePr>
        <p:xfrm>
          <a:off x="747027" y="359818"/>
          <a:ext cx="2817250" cy="3186359"/>
        </p:xfrm>
        <a:graphic>
          <a:graphicData uri="http://schemas.openxmlformats.org/presentationml/2006/ole">
            <mc:AlternateContent xmlns:mc="http://schemas.openxmlformats.org/markup-compatibility/2006">
              <mc:Choice xmlns:v="urn:schemas-microsoft-com:vml" Requires="v">
                <p:oleObj name="Prism 9" r:id="rId3" imgW="2011425" imgH="2274957" progId="Prism9.Document">
                  <p:embed/>
                </p:oleObj>
              </mc:Choice>
              <mc:Fallback>
                <p:oleObj name="Prism 9" r:id="rId3" imgW="2011425" imgH="2274957" progId="Prism9.Document">
                  <p:embed/>
                  <p:pic>
                    <p:nvPicPr>
                      <p:cNvPr id="2" name="オブジェクト 1">
                        <a:extLst>
                          <a:ext uri="{FF2B5EF4-FFF2-40B4-BE49-F238E27FC236}">
                            <a16:creationId xmlns:a16="http://schemas.microsoft.com/office/drawing/2014/main" id="{D44CEAF4-56E1-466A-FC84-E21F57864C9D}"/>
                          </a:ext>
                        </a:extLst>
                      </p:cNvPr>
                      <p:cNvPicPr/>
                      <p:nvPr/>
                    </p:nvPicPr>
                    <p:blipFill>
                      <a:blip r:embed="rId4"/>
                      <a:stretch>
                        <a:fillRect/>
                      </a:stretch>
                    </p:blipFill>
                    <p:spPr>
                      <a:xfrm>
                        <a:off x="747027" y="359818"/>
                        <a:ext cx="2817250" cy="3186359"/>
                      </a:xfrm>
                      <a:prstGeom prst="rect">
                        <a:avLst/>
                      </a:prstGeom>
                    </p:spPr>
                  </p:pic>
                </p:oleObj>
              </mc:Fallback>
            </mc:AlternateContent>
          </a:graphicData>
        </a:graphic>
      </p:graphicFrame>
      <p:graphicFrame>
        <p:nvGraphicFramePr>
          <p:cNvPr id="3" name="オブジェクト 2">
            <a:extLst>
              <a:ext uri="{FF2B5EF4-FFF2-40B4-BE49-F238E27FC236}">
                <a16:creationId xmlns:a16="http://schemas.microsoft.com/office/drawing/2014/main" id="{3851CF08-3D58-AE5A-F1C2-826B2F7C81C3}"/>
              </a:ext>
            </a:extLst>
          </p:cNvPr>
          <p:cNvGraphicFramePr>
            <a:graphicFrameLocks noChangeAspect="1"/>
          </p:cNvGraphicFramePr>
          <p:nvPr>
            <p:extLst>
              <p:ext uri="{D42A27DB-BD31-4B8C-83A1-F6EECF244321}">
                <p14:modId xmlns:p14="http://schemas.microsoft.com/office/powerpoint/2010/main" val="3696897477"/>
              </p:ext>
            </p:extLst>
          </p:nvPr>
        </p:nvGraphicFramePr>
        <p:xfrm>
          <a:off x="6926223" y="377461"/>
          <a:ext cx="2753201" cy="3113919"/>
        </p:xfrm>
        <a:graphic>
          <a:graphicData uri="http://schemas.openxmlformats.org/presentationml/2006/ole">
            <mc:AlternateContent xmlns:mc="http://schemas.openxmlformats.org/markup-compatibility/2006">
              <mc:Choice xmlns:v="urn:schemas-microsoft-com:vml" Requires="v">
                <p:oleObj name="Prism 9" r:id="rId5" imgW="2011425" imgH="2274957" progId="Prism9.Document">
                  <p:embed/>
                </p:oleObj>
              </mc:Choice>
              <mc:Fallback>
                <p:oleObj name="Prism 9" r:id="rId5" imgW="2011425" imgH="2274957" progId="Prism9.Document">
                  <p:embed/>
                  <p:pic>
                    <p:nvPicPr>
                      <p:cNvPr id="3" name="オブジェクト 2">
                        <a:extLst>
                          <a:ext uri="{FF2B5EF4-FFF2-40B4-BE49-F238E27FC236}">
                            <a16:creationId xmlns:a16="http://schemas.microsoft.com/office/drawing/2014/main" id="{3851CF08-3D58-AE5A-F1C2-826B2F7C81C3}"/>
                          </a:ext>
                        </a:extLst>
                      </p:cNvPr>
                      <p:cNvPicPr/>
                      <p:nvPr/>
                    </p:nvPicPr>
                    <p:blipFill>
                      <a:blip r:embed="rId6"/>
                      <a:stretch>
                        <a:fillRect/>
                      </a:stretch>
                    </p:blipFill>
                    <p:spPr>
                      <a:xfrm>
                        <a:off x="6926223" y="377461"/>
                        <a:ext cx="2753201" cy="3113919"/>
                      </a:xfrm>
                      <a:prstGeom prst="rect">
                        <a:avLst/>
                      </a:prstGeom>
                    </p:spPr>
                  </p:pic>
                </p:oleObj>
              </mc:Fallback>
            </mc:AlternateContent>
          </a:graphicData>
        </a:graphic>
      </p:graphicFrame>
      <p:graphicFrame>
        <p:nvGraphicFramePr>
          <p:cNvPr id="4" name="オブジェクト 3">
            <a:extLst>
              <a:ext uri="{FF2B5EF4-FFF2-40B4-BE49-F238E27FC236}">
                <a16:creationId xmlns:a16="http://schemas.microsoft.com/office/drawing/2014/main" id="{E0B9CCB5-A00E-7E6E-8D14-532D27C3F79F}"/>
              </a:ext>
            </a:extLst>
          </p:cNvPr>
          <p:cNvGraphicFramePr>
            <a:graphicFrameLocks noChangeAspect="1"/>
          </p:cNvGraphicFramePr>
          <p:nvPr>
            <p:extLst>
              <p:ext uri="{D42A27DB-BD31-4B8C-83A1-F6EECF244321}">
                <p14:modId xmlns:p14="http://schemas.microsoft.com/office/powerpoint/2010/main" val="2565163295"/>
              </p:ext>
            </p:extLst>
          </p:nvPr>
        </p:nvGraphicFramePr>
        <p:xfrm>
          <a:off x="751476" y="3519234"/>
          <a:ext cx="2918316" cy="3305887"/>
        </p:xfrm>
        <a:graphic>
          <a:graphicData uri="http://schemas.openxmlformats.org/presentationml/2006/ole">
            <mc:AlternateContent xmlns:mc="http://schemas.openxmlformats.org/markup-compatibility/2006">
              <mc:Choice xmlns:v="urn:schemas-microsoft-com:vml" Requires="v">
                <p:oleObj name="Prism 9" r:id="rId7" imgW="2008545" imgH="2274957" progId="Prism9.Document">
                  <p:embed/>
                </p:oleObj>
              </mc:Choice>
              <mc:Fallback>
                <p:oleObj name="Prism 9" r:id="rId7" imgW="2008545" imgH="2274957" progId="Prism9.Document">
                  <p:embed/>
                  <p:pic>
                    <p:nvPicPr>
                      <p:cNvPr id="4" name="オブジェクト 3">
                        <a:extLst>
                          <a:ext uri="{FF2B5EF4-FFF2-40B4-BE49-F238E27FC236}">
                            <a16:creationId xmlns:a16="http://schemas.microsoft.com/office/drawing/2014/main" id="{E0B9CCB5-A00E-7E6E-8D14-532D27C3F79F}"/>
                          </a:ext>
                        </a:extLst>
                      </p:cNvPr>
                      <p:cNvPicPr/>
                      <p:nvPr/>
                    </p:nvPicPr>
                    <p:blipFill>
                      <a:blip r:embed="rId8"/>
                      <a:stretch>
                        <a:fillRect/>
                      </a:stretch>
                    </p:blipFill>
                    <p:spPr>
                      <a:xfrm>
                        <a:off x="751476" y="3519234"/>
                        <a:ext cx="2918316" cy="3305887"/>
                      </a:xfrm>
                      <a:prstGeom prst="rect">
                        <a:avLst/>
                      </a:prstGeom>
                    </p:spPr>
                  </p:pic>
                </p:oleObj>
              </mc:Fallback>
            </mc:AlternateContent>
          </a:graphicData>
        </a:graphic>
      </p:graphicFrame>
      <p:graphicFrame>
        <p:nvGraphicFramePr>
          <p:cNvPr id="9" name="オブジェクト 8">
            <a:extLst>
              <a:ext uri="{FF2B5EF4-FFF2-40B4-BE49-F238E27FC236}">
                <a16:creationId xmlns:a16="http://schemas.microsoft.com/office/drawing/2014/main" id="{DE8E6722-4C26-4884-3729-DC4FBD85908D}"/>
              </a:ext>
            </a:extLst>
          </p:cNvPr>
          <p:cNvGraphicFramePr>
            <a:graphicFrameLocks noChangeAspect="1"/>
          </p:cNvGraphicFramePr>
          <p:nvPr>
            <p:extLst>
              <p:ext uri="{D42A27DB-BD31-4B8C-83A1-F6EECF244321}">
                <p14:modId xmlns:p14="http://schemas.microsoft.com/office/powerpoint/2010/main" val="124920683"/>
              </p:ext>
            </p:extLst>
          </p:nvPr>
        </p:nvGraphicFramePr>
        <p:xfrm>
          <a:off x="6807563" y="3546177"/>
          <a:ext cx="2887601" cy="3271093"/>
        </p:xfrm>
        <a:graphic>
          <a:graphicData uri="http://schemas.openxmlformats.org/presentationml/2006/ole">
            <mc:AlternateContent xmlns:mc="http://schemas.openxmlformats.org/markup-compatibility/2006">
              <mc:Choice xmlns:v="urn:schemas-microsoft-com:vml" Requires="v">
                <p:oleObj name="Prism 9" r:id="rId9" imgW="2008545" imgH="2274957" progId="Prism9.Document">
                  <p:embed/>
                </p:oleObj>
              </mc:Choice>
              <mc:Fallback>
                <p:oleObj name="Prism 9" r:id="rId9" imgW="2008545" imgH="2274957" progId="Prism9.Document">
                  <p:embed/>
                  <p:pic>
                    <p:nvPicPr>
                      <p:cNvPr id="9" name="オブジェクト 8">
                        <a:extLst>
                          <a:ext uri="{FF2B5EF4-FFF2-40B4-BE49-F238E27FC236}">
                            <a16:creationId xmlns:a16="http://schemas.microsoft.com/office/drawing/2014/main" id="{DE8E6722-4C26-4884-3729-DC4FBD85908D}"/>
                          </a:ext>
                        </a:extLst>
                      </p:cNvPr>
                      <p:cNvPicPr/>
                      <p:nvPr/>
                    </p:nvPicPr>
                    <p:blipFill>
                      <a:blip r:embed="rId10"/>
                      <a:stretch>
                        <a:fillRect/>
                      </a:stretch>
                    </p:blipFill>
                    <p:spPr>
                      <a:xfrm>
                        <a:off x="6807563" y="3546177"/>
                        <a:ext cx="2887601" cy="3271093"/>
                      </a:xfrm>
                      <a:prstGeom prst="rect">
                        <a:avLst/>
                      </a:prstGeom>
                    </p:spPr>
                  </p:pic>
                </p:oleObj>
              </mc:Fallback>
            </mc:AlternateContent>
          </a:graphicData>
        </a:graphic>
      </p:graphicFrame>
    </p:spTree>
    <p:extLst>
      <p:ext uri="{BB962C8B-B14F-4D97-AF65-F5344CB8AC3E}">
        <p14:creationId xmlns:p14="http://schemas.microsoft.com/office/powerpoint/2010/main" val="320171234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27</TotalTime>
  <Words>225</Words>
  <Application>Microsoft Office PowerPoint</Application>
  <PresentationFormat>ワイド画面</PresentationFormat>
  <Paragraphs>22</Paragraphs>
  <Slides>1</Slides>
  <Notes>1</Notes>
  <HiddenSlides>0</HiddenSlides>
  <MMClips>0</MMClips>
  <ScaleCrop>false</ScaleCrop>
  <HeadingPairs>
    <vt:vector size="8" baseType="variant">
      <vt:variant>
        <vt:lpstr>使用されているフォント</vt:lpstr>
      </vt:variant>
      <vt:variant>
        <vt:i4>5</vt:i4>
      </vt:variant>
      <vt:variant>
        <vt:lpstr>テーマ</vt:lpstr>
      </vt:variant>
      <vt:variant>
        <vt:i4>1</vt:i4>
      </vt:variant>
      <vt:variant>
        <vt:lpstr>埋め込まれた OLE サーバー</vt:lpstr>
      </vt:variant>
      <vt:variant>
        <vt:i4>1</vt:i4>
      </vt:variant>
      <vt:variant>
        <vt:lpstr>スライド タイトル</vt:lpstr>
      </vt:variant>
      <vt:variant>
        <vt:i4>1</vt:i4>
      </vt:variant>
    </vt:vector>
  </HeadingPairs>
  <TitlesOfParts>
    <vt:vector size="8" baseType="lpstr">
      <vt:lpstr>游ゴシック</vt:lpstr>
      <vt:lpstr>游ゴシック Light</vt:lpstr>
      <vt:lpstr>游明朝</vt:lpstr>
      <vt:lpstr>Arial</vt:lpstr>
      <vt:lpstr>Times New Roman</vt:lpstr>
      <vt:lpstr>Office テーマ</vt:lpstr>
      <vt:lpstr>Prism 9</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雄康 大野</dc:creator>
  <cp:lastModifiedBy>雄康 大野</cp:lastModifiedBy>
  <cp:revision>10</cp:revision>
  <dcterms:created xsi:type="dcterms:W3CDTF">2023-08-29T12:52:27Z</dcterms:created>
  <dcterms:modified xsi:type="dcterms:W3CDTF">2024-11-12T11:53:08Z</dcterms:modified>
</cp:coreProperties>
</file>